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CC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69" autoAdjust="0"/>
    <p:restoredTop sz="94660"/>
  </p:normalViewPr>
  <p:slideViewPr>
    <p:cSldViewPr snapToGrid="0">
      <p:cViewPr varScale="1">
        <p:scale>
          <a:sx n="61" d="100"/>
          <a:sy n="61" d="100"/>
        </p:scale>
        <p:origin x="43" y="40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gMADS23-06</a:t>
            </a:r>
            <a:endParaRPr lang="zh-CN" altLang="en-US" sz="800" i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9901762288282505"/>
          <c:y val="1.53229153595938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PgMADS23-06'!$H$1</c:f>
              <c:strCache>
                <c:ptCount val="1"/>
                <c:pt idx="0">
                  <c:v>Rg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4578031496062992"/>
                  <c:y val="-0.58342082239720039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rgbClr val="0070C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/>
                      <a:t>y = -0.0613x + 1.608</a:t>
                    </a:r>
                    <a:br>
                      <a:rPr lang="en-US" altLang="zh-CN" sz="800" baseline="0"/>
                    </a:br>
                    <a:r>
                      <a:rPr lang="en-US" altLang="zh-CN" sz="800" i="1" baseline="0"/>
                      <a:t>r </a:t>
                    </a:r>
                    <a:r>
                      <a:rPr lang="en-US" altLang="zh-CN" sz="800" baseline="0"/>
                      <a:t>= -0.1662, </a:t>
                    </a:r>
                    <a:r>
                      <a:rPr lang="en-US" altLang="zh-CN" sz="800" i="1" baseline="0"/>
                      <a:t>P</a:t>
                    </a:r>
                    <a:r>
                      <a:rPr lang="en-US" altLang="zh-CN" sz="800" baseline="0"/>
                      <a:t> = 0.34</a:t>
                    </a:r>
                    <a:endParaRPr lang="en-US" altLang="zh-CN" sz="80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rgbClr val="0070C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PgMADS23-06'!$G$2:$G$36</c:f>
              <c:numCache>
                <c:formatCode>General</c:formatCode>
                <c:ptCount val="35"/>
                <c:pt idx="0">
                  <c:v>0.57173300000000005</c:v>
                </c:pt>
                <c:pt idx="1">
                  <c:v>2.9301159999999999</c:v>
                </c:pt>
                <c:pt idx="2">
                  <c:v>2.7728860000000002</c:v>
                </c:pt>
                <c:pt idx="3">
                  <c:v>1.6134109999999999</c:v>
                </c:pt>
                <c:pt idx="4">
                  <c:v>1.667206</c:v>
                </c:pt>
                <c:pt idx="5">
                  <c:v>1.3470040000000001</c:v>
                </c:pt>
                <c:pt idx="6">
                  <c:v>0.97332799999999997</c:v>
                </c:pt>
                <c:pt idx="7">
                  <c:v>0.78714300000000004</c:v>
                </c:pt>
                <c:pt idx="8">
                  <c:v>1.536397</c:v>
                </c:pt>
                <c:pt idx="9">
                  <c:v>0.96204000000000001</c:v>
                </c:pt>
                <c:pt idx="10">
                  <c:v>2.1951320000000001</c:v>
                </c:pt>
                <c:pt idx="11">
                  <c:v>1.203578</c:v>
                </c:pt>
                <c:pt idx="12">
                  <c:v>0.70018499999999995</c:v>
                </c:pt>
                <c:pt idx="13">
                  <c:v>1.0080039999999999</c:v>
                </c:pt>
                <c:pt idx="14">
                  <c:v>0.98201000000000005</c:v>
                </c:pt>
                <c:pt idx="15">
                  <c:v>0.68570900000000001</c:v>
                </c:pt>
                <c:pt idx="16">
                  <c:v>0.28387600000000002</c:v>
                </c:pt>
                <c:pt idx="17">
                  <c:v>0.67860600000000004</c:v>
                </c:pt>
                <c:pt idx="18">
                  <c:v>1.4391130000000001</c:v>
                </c:pt>
                <c:pt idx="19">
                  <c:v>0.35392000000000001</c:v>
                </c:pt>
                <c:pt idx="20">
                  <c:v>1.1001890000000001</c:v>
                </c:pt>
                <c:pt idx="21">
                  <c:v>1.5374429999999999</c:v>
                </c:pt>
                <c:pt idx="22">
                  <c:v>1.432868</c:v>
                </c:pt>
                <c:pt idx="23">
                  <c:v>1.2505999999999999</c:v>
                </c:pt>
                <c:pt idx="24">
                  <c:v>0.49108299999999999</c:v>
                </c:pt>
                <c:pt idx="25">
                  <c:v>0.95883799999999997</c:v>
                </c:pt>
                <c:pt idx="26">
                  <c:v>0.68188300000000002</c:v>
                </c:pt>
                <c:pt idx="27">
                  <c:v>1.4644250000000001</c:v>
                </c:pt>
                <c:pt idx="28">
                  <c:v>1.1522509999999999</c:v>
                </c:pt>
                <c:pt idx="29">
                  <c:v>0.77120900000000003</c:v>
                </c:pt>
                <c:pt idx="30">
                  <c:v>0.575658</c:v>
                </c:pt>
                <c:pt idx="31">
                  <c:v>0.99136400000000002</c:v>
                </c:pt>
                <c:pt idx="32">
                  <c:v>0</c:v>
                </c:pt>
                <c:pt idx="33">
                  <c:v>2.4532430000000001</c:v>
                </c:pt>
                <c:pt idx="34">
                  <c:v>0.83063699999999996</c:v>
                </c:pt>
              </c:numCache>
            </c:numRef>
          </c:xVal>
          <c:yVal>
            <c:numRef>
              <c:f>'PgMADS23-06'!$H$2:$H$36</c:f>
              <c:numCache>
                <c:formatCode>General</c:formatCode>
                <c:ptCount val="35"/>
                <c:pt idx="0">
                  <c:v>1.3839999999999999</c:v>
                </c:pt>
                <c:pt idx="1">
                  <c:v>1.2130000000000001</c:v>
                </c:pt>
                <c:pt idx="2">
                  <c:v>1.2450000000000001</c:v>
                </c:pt>
                <c:pt idx="3">
                  <c:v>1.675</c:v>
                </c:pt>
                <c:pt idx="4">
                  <c:v>1.5389999999999999</c:v>
                </c:pt>
                <c:pt idx="5">
                  <c:v>1.8120000000000001</c:v>
                </c:pt>
                <c:pt idx="6">
                  <c:v>1.5629999999999999</c:v>
                </c:pt>
                <c:pt idx="7">
                  <c:v>1.554</c:v>
                </c:pt>
                <c:pt idx="8">
                  <c:v>1.4610000000000001</c:v>
                </c:pt>
                <c:pt idx="9">
                  <c:v>1.4770000000000001</c:v>
                </c:pt>
                <c:pt idx="10">
                  <c:v>1.385</c:v>
                </c:pt>
                <c:pt idx="11">
                  <c:v>1.6259999999999999</c:v>
                </c:pt>
                <c:pt idx="12">
                  <c:v>1.335</c:v>
                </c:pt>
                <c:pt idx="13">
                  <c:v>1.4339999999999999</c:v>
                </c:pt>
                <c:pt idx="14">
                  <c:v>1.335</c:v>
                </c:pt>
                <c:pt idx="15">
                  <c:v>1.64</c:v>
                </c:pt>
                <c:pt idx="16">
                  <c:v>1.6950000000000001</c:v>
                </c:pt>
                <c:pt idx="17">
                  <c:v>1.577</c:v>
                </c:pt>
                <c:pt idx="18">
                  <c:v>1.5920000000000001</c:v>
                </c:pt>
                <c:pt idx="19">
                  <c:v>1.613</c:v>
                </c:pt>
                <c:pt idx="20">
                  <c:v>1.6679999999999999</c:v>
                </c:pt>
                <c:pt idx="21">
                  <c:v>1.2629999999999999</c:v>
                </c:pt>
                <c:pt idx="22">
                  <c:v>1.383</c:v>
                </c:pt>
                <c:pt idx="23">
                  <c:v>1.1859999999999999</c:v>
                </c:pt>
                <c:pt idx="24">
                  <c:v>1.179</c:v>
                </c:pt>
                <c:pt idx="25">
                  <c:v>1.2290000000000001</c:v>
                </c:pt>
                <c:pt idx="26">
                  <c:v>1.093</c:v>
                </c:pt>
                <c:pt idx="27">
                  <c:v>2.0139999999999998</c:v>
                </c:pt>
                <c:pt idx="28">
                  <c:v>1.974</c:v>
                </c:pt>
                <c:pt idx="29">
                  <c:v>1.9330000000000001</c:v>
                </c:pt>
                <c:pt idx="30">
                  <c:v>1.617</c:v>
                </c:pt>
                <c:pt idx="31">
                  <c:v>1.7689999999999999</c:v>
                </c:pt>
                <c:pt idx="32">
                  <c:v>1.633</c:v>
                </c:pt>
                <c:pt idx="33">
                  <c:v>1.7250000000000001</c:v>
                </c:pt>
                <c:pt idx="34">
                  <c:v>1.985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5B5-40BE-AE88-87DE8E9ADA49}"/>
            </c:ext>
          </c:extLst>
        </c:ser>
        <c:ser>
          <c:idx val="1"/>
          <c:order val="1"/>
          <c:tx>
            <c:strRef>
              <c:f>'PgMADS23-06'!$I$1</c:f>
              <c:strCache>
                <c:ptCount val="1"/>
                <c:pt idx="0">
                  <c:v>Rb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1689304174792294"/>
                  <c:y val="-0.5157407764897412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bg2">
                            <a:lumMod val="50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 dirty="0"/>
                      <a:t>y = -1.803x + 7.9862</a:t>
                    </a:r>
                    <a:br>
                      <a:rPr lang="en-US" altLang="zh-CN" sz="800" baseline="0" dirty="0"/>
                    </a:br>
                    <a:r>
                      <a:rPr lang="en-US" altLang="zh-CN" sz="800" i="1" baseline="0" dirty="0"/>
                      <a:t>r</a:t>
                    </a:r>
                    <a:r>
                      <a:rPr lang="en-US" altLang="zh-CN" sz="800" baseline="0" dirty="0"/>
                      <a:t> = -0.4448,</a:t>
                    </a:r>
                    <a:r>
                      <a:rPr lang="en-US" altLang="zh-CN" sz="800" i="1" baseline="0" dirty="0"/>
                      <a:t> P </a:t>
                    </a:r>
                    <a:r>
                      <a:rPr lang="en-US" altLang="zh-CN" sz="800" baseline="0" dirty="0"/>
                      <a:t>= 0.0074</a:t>
                    </a:r>
                    <a:endParaRPr lang="en-US" altLang="zh-CN" sz="800" dirty="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PgMADS23-06'!$G$2:$G$36</c:f>
              <c:numCache>
                <c:formatCode>General</c:formatCode>
                <c:ptCount val="35"/>
                <c:pt idx="0">
                  <c:v>0.57173300000000005</c:v>
                </c:pt>
                <c:pt idx="1">
                  <c:v>2.9301159999999999</c:v>
                </c:pt>
                <c:pt idx="2">
                  <c:v>2.7728860000000002</c:v>
                </c:pt>
                <c:pt idx="3">
                  <c:v>1.6134109999999999</c:v>
                </c:pt>
                <c:pt idx="4">
                  <c:v>1.667206</c:v>
                </c:pt>
                <c:pt idx="5">
                  <c:v>1.3470040000000001</c:v>
                </c:pt>
                <c:pt idx="6">
                  <c:v>0.97332799999999997</c:v>
                </c:pt>
                <c:pt idx="7">
                  <c:v>0.78714300000000004</c:v>
                </c:pt>
                <c:pt idx="8">
                  <c:v>1.536397</c:v>
                </c:pt>
                <c:pt idx="9">
                  <c:v>0.96204000000000001</c:v>
                </c:pt>
                <c:pt idx="10">
                  <c:v>2.1951320000000001</c:v>
                </c:pt>
                <c:pt idx="11">
                  <c:v>1.203578</c:v>
                </c:pt>
                <c:pt idx="12">
                  <c:v>0.70018499999999995</c:v>
                </c:pt>
                <c:pt idx="13">
                  <c:v>1.0080039999999999</c:v>
                </c:pt>
                <c:pt idx="14">
                  <c:v>0.98201000000000005</c:v>
                </c:pt>
                <c:pt idx="15">
                  <c:v>0.68570900000000001</c:v>
                </c:pt>
                <c:pt idx="16">
                  <c:v>0.28387600000000002</c:v>
                </c:pt>
                <c:pt idx="17">
                  <c:v>0.67860600000000004</c:v>
                </c:pt>
                <c:pt idx="18">
                  <c:v>1.4391130000000001</c:v>
                </c:pt>
                <c:pt idx="19">
                  <c:v>0.35392000000000001</c:v>
                </c:pt>
                <c:pt idx="20">
                  <c:v>1.1001890000000001</c:v>
                </c:pt>
                <c:pt idx="21">
                  <c:v>1.5374429999999999</c:v>
                </c:pt>
                <c:pt idx="22">
                  <c:v>1.432868</c:v>
                </c:pt>
                <c:pt idx="23">
                  <c:v>1.2505999999999999</c:v>
                </c:pt>
                <c:pt idx="24">
                  <c:v>0.49108299999999999</c:v>
                </c:pt>
                <c:pt idx="25">
                  <c:v>0.95883799999999997</c:v>
                </c:pt>
                <c:pt idx="26">
                  <c:v>0.68188300000000002</c:v>
                </c:pt>
                <c:pt idx="27">
                  <c:v>1.4644250000000001</c:v>
                </c:pt>
                <c:pt idx="28">
                  <c:v>1.1522509999999999</c:v>
                </c:pt>
                <c:pt idx="29">
                  <c:v>0.77120900000000003</c:v>
                </c:pt>
                <c:pt idx="30">
                  <c:v>0.575658</c:v>
                </c:pt>
                <c:pt idx="31">
                  <c:v>0.99136400000000002</c:v>
                </c:pt>
                <c:pt idx="32">
                  <c:v>0</c:v>
                </c:pt>
                <c:pt idx="33">
                  <c:v>2.4532430000000001</c:v>
                </c:pt>
                <c:pt idx="34">
                  <c:v>0.83063699999999996</c:v>
                </c:pt>
              </c:numCache>
            </c:numRef>
          </c:xVal>
          <c:yVal>
            <c:numRef>
              <c:f>'PgMADS23-06'!$I$2:$I$36</c:f>
              <c:numCache>
                <c:formatCode>General</c:formatCode>
                <c:ptCount val="35"/>
                <c:pt idx="0">
                  <c:v>2.1715968170354896</c:v>
                </c:pt>
                <c:pt idx="1">
                  <c:v>2.0525280068302401</c:v>
                </c:pt>
                <c:pt idx="2">
                  <c:v>2.1120624119328646</c:v>
                </c:pt>
                <c:pt idx="3">
                  <c:v>2.5559379017952448</c:v>
                </c:pt>
                <c:pt idx="4">
                  <c:v>2.7278741622905476</c:v>
                </c:pt>
                <c:pt idx="5">
                  <c:v>2.8998104227858503</c:v>
                </c:pt>
                <c:pt idx="6">
                  <c:v>1.9736041936693041</c:v>
                </c:pt>
                <c:pt idx="7">
                  <c:v>2.5979172330463434</c:v>
                </c:pt>
                <c:pt idx="8">
                  <c:v>3.2222302724233827</c:v>
                </c:pt>
                <c:pt idx="9">
                  <c:v>3.904624387136213</c:v>
                </c:pt>
                <c:pt idx="10">
                  <c:v>4.1162594598555193</c:v>
                </c:pt>
                <c:pt idx="11">
                  <c:v>3.692989314416907</c:v>
                </c:pt>
                <c:pt idx="12">
                  <c:v>5.0961954554617259</c:v>
                </c:pt>
                <c:pt idx="13">
                  <c:v>5.2293647962536181</c:v>
                </c:pt>
                <c:pt idx="14">
                  <c:v>4.9630261146698338</c:v>
                </c:pt>
                <c:pt idx="15">
                  <c:v>5.4236484900219031</c:v>
                </c:pt>
                <c:pt idx="16">
                  <c:v>6.4026095597056454</c:v>
                </c:pt>
                <c:pt idx="17">
                  <c:v>7.3815706293893868</c:v>
                </c:pt>
                <c:pt idx="18">
                  <c:v>7.0548002083428552</c:v>
                </c:pt>
                <c:pt idx="19">
                  <c:v>6.3629253077424854</c:v>
                </c:pt>
                <c:pt idx="20">
                  <c:v>6.7088627580426703</c:v>
                </c:pt>
                <c:pt idx="21">
                  <c:v>7.6615008049587212</c:v>
                </c:pt>
                <c:pt idx="22">
                  <c:v>7.1563303367208864</c:v>
                </c:pt>
                <c:pt idx="23">
                  <c:v>7.4089155708398042</c:v>
                </c:pt>
                <c:pt idx="24">
                  <c:v>10.37559784428767</c:v>
                </c:pt>
                <c:pt idx="25">
                  <c:v>10.753920372229492</c:v>
                </c:pt>
                <c:pt idx="26">
                  <c:v>10.564759108258581</c:v>
                </c:pt>
                <c:pt idx="27">
                  <c:v>7.8490123896074229</c:v>
                </c:pt>
                <c:pt idx="28">
                  <c:v>8.1426393742903791</c:v>
                </c:pt>
                <c:pt idx="29">
                  <c:v>7.5553854049244666</c:v>
                </c:pt>
                <c:pt idx="30">
                  <c:v>9.8427135206888252</c:v>
                </c:pt>
                <c:pt idx="31">
                  <c:v>8.7293285798814733</c:v>
                </c:pt>
                <c:pt idx="32">
                  <c:v>9.2860210502851501</c:v>
                </c:pt>
                <c:pt idx="33">
                  <c:v>6.3003687616803914</c:v>
                </c:pt>
                <c:pt idx="34">
                  <c:v>6.42953011886726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25B5-40BE-AE88-87DE8E9ADA49}"/>
            </c:ext>
          </c:extLst>
        </c:ser>
        <c:ser>
          <c:idx val="2"/>
          <c:order val="2"/>
          <c:tx>
            <c:strRef>
              <c:f>'PgMADS23-06'!$J$1</c:f>
              <c:strCache>
                <c:ptCount val="1"/>
                <c:pt idx="0">
                  <c:v>Rd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7223812300750355"/>
                  <c:y val="-0.5990644575929268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zh-CN" altLang="en-US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-0.4105x + 1.8496</a:t>
                    </a:r>
                    <a:br>
                      <a:rPr lang="zh-CN" altLang="en-US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zh-CN" altLang="en-US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</a:t>
                    </a:r>
                    <a:r>
                      <a:rPr lang="en-US" altLang="zh-CN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r>
                      <a:rPr lang="zh-CN" altLang="en-US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</a:t>
                    </a:r>
                    <a:r>
                      <a:rPr lang="en-US" altLang="zh-CN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533, </a:t>
                    </a:r>
                    <a:r>
                      <a:rPr lang="en-US" altLang="zh-CN" sz="800" i="1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0062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accent2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PgMADS23-06'!$G$2:$G$36</c:f>
              <c:numCache>
                <c:formatCode>General</c:formatCode>
                <c:ptCount val="35"/>
                <c:pt idx="0">
                  <c:v>0.57173300000000005</c:v>
                </c:pt>
                <c:pt idx="1">
                  <c:v>2.9301159999999999</c:v>
                </c:pt>
                <c:pt idx="2">
                  <c:v>2.7728860000000002</c:v>
                </c:pt>
                <c:pt idx="3">
                  <c:v>1.6134109999999999</c:v>
                </c:pt>
                <c:pt idx="4">
                  <c:v>1.667206</c:v>
                </c:pt>
                <c:pt idx="5">
                  <c:v>1.3470040000000001</c:v>
                </c:pt>
                <c:pt idx="6">
                  <c:v>0.97332799999999997</c:v>
                </c:pt>
                <c:pt idx="7">
                  <c:v>0.78714300000000004</c:v>
                </c:pt>
                <c:pt idx="8">
                  <c:v>1.536397</c:v>
                </c:pt>
                <c:pt idx="9">
                  <c:v>0.96204000000000001</c:v>
                </c:pt>
                <c:pt idx="10">
                  <c:v>2.1951320000000001</c:v>
                </c:pt>
                <c:pt idx="11">
                  <c:v>1.203578</c:v>
                </c:pt>
                <c:pt idx="12">
                  <c:v>0.70018499999999995</c:v>
                </c:pt>
                <c:pt idx="13">
                  <c:v>1.0080039999999999</c:v>
                </c:pt>
                <c:pt idx="14">
                  <c:v>0.98201000000000005</c:v>
                </c:pt>
                <c:pt idx="15">
                  <c:v>0.68570900000000001</c:v>
                </c:pt>
                <c:pt idx="16">
                  <c:v>0.28387600000000002</c:v>
                </c:pt>
                <c:pt idx="17">
                  <c:v>0.67860600000000004</c:v>
                </c:pt>
                <c:pt idx="18">
                  <c:v>1.4391130000000001</c:v>
                </c:pt>
                <c:pt idx="19">
                  <c:v>0.35392000000000001</c:v>
                </c:pt>
                <c:pt idx="20">
                  <c:v>1.1001890000000001</c:v>
                </c:pt>
                <c:pt idx="21">
                  <c:v>1.5374429999999999</c:v>
                </c:pt>
                <c:pt idx="22">
                  <c:v>1.432868</c:v>
                </c:pt>
                <c:pt idx="23">
                  <c:v>1.2505999999999999</c:v>
                </c:pt>
                <c:pt idx="24">
                  <c:v>0.49108299999999999</c:v>
                </c:pt>
                <c:pt idx="25">
                  <c:v>0.95883799999999997</c:v>
                </c:pt>
                <c:pt idx="26">
                  <c:v>0.68188300000000002</c:v>
                </c:pt>
                <c:pt idx="27">
                  <c:v>1.4644250000000001</c:v>
                </c:pt>
                <c:pt idx="28">
                  <c:v>1.1522509999999999</c:v>
                </c:pt>
                <c:pt idx="29">
                  <c:v>0.77120900000000003</c:v>
                </c:pt>
                <c:pt idx="30">
                  <c:v>0.575658</c:v>
                </c:pt>
                <c:pt idx="31">
                  <c:v>0.99136400000000002</c:v>
                </c:pt>
                <c:pt idx="32">
                  <c:v>0</c:v>
                </c:pt>
                <c:pt idx="33">
                  <c:v>2.4532430000000001</c:v>
                </c:pt>
                <c:pt idx="34">
                  <c:v>0.83063699999999996</c:v>
                </c:pt>
              </c:numCache>
            </c:numRef>
          </c:xVal>
          <c:yVal>
            <c:numRef>
              <c:f>'PgMADS23-06'!$J$2:$J$36</c:f>
              <c:numCache>
                <c:formatCode>General</c:formatCode>
                <c:ptCount val="35"/>
                <c:pt idx="0">
                  <c:v>0.60469553389179131</c:v>
                </c:pt>
                <c:pt idx="1">
                  <c:v>0.67930434672093831</c:v>
                </c:pt>
                <c:pt idx="2">
                  <c:v>0.61757654900337511</c:v>
                </c:pt>
                <c:pt idx="3">
                  <c:v>0.58679909011832021</c:v>
                </c:pt>
                <c:pt idx="4">
                  <c:v>0.62948409466337885</c:v>
                </c:pt>
                <c:pt idx="5">
                  <c:v>0.67216909920843748</c:v>
                </c:pt>
                <c:pt idx="6">
                  <c:v>0.87081751476292701</c:v>
                </c:pt>
                <c:pt idx="7">
                  <c:v>0.83690906987468916</c:v>
                </c:pt>
                <c:pt idx="8">
                  <c:v>0.90472595965116487</c:v>
                </c:pt>
                <c:pt idx="9">
                  <c:v>1.0236300411323342</c:v>
                </c:pt>
                <c:pt idx="10">
                  <c:v>0.95428468599889549</c:v>
                </c:pt>
                <c:pt idx="11">
                  <c:v>0.95566929354793895</c:v>
                </c:pt>
                <c:pt idx="12">
                  <c:v>0.99502701148142159</c:v>
                </c:pt>
                <c:pt idx="13">
                  <c:v>0.95649476075034179</c:v>
                </c:pt>
                <c:pt idx="14">
                  <c:v>0.9113322857649232</c:v>
                </c:pt>
                <c:pt idx="15">
                  <c:v>1.4515241625108004</c:v>
                </c:pt>
                <c:pt idx="16">
                  <c:v>1.572127039421324</c:v>
                </c:pt>
                <c:pt idx="17">
                  <c:v>1.6927299163318479</c:v>
                </c:pt>
                <c:pt idx="18">
                  <c:v>1.2248479157351744</c:v>
                </c:pt>
                <c:pt idx="19">
                  <c:v>1.2917019582872464</c:v>
                </c:pt>
                <c:pt idx="20">
                  <c:v>1.1579938731831021</c:v>
                </c:pt>
                <c:pt idx="21">
                  <c:v>1.8762668984631061</c:v>
                </c:pt>
                <c:pt idx="22">
                  <c:v>1.8983492237448403</c:v>
                </c:pt>
                <c:pt idx="23">
                  <c:v>1.8873080611039732</c:v>
                </c:pt>
                <c:pt idx="24">
                  <c:v>2.3185507016028506</c:v>
                </c:pt>
                <c:pt idx="25">
                  <c:v>2.4779851319663768</c:v>
                </c:pt>
                <c:pt idx="26">
                  <c:v>2.1591162712393244</c:v>
                </c:pt>
                <c:pt idx="27">
                  <c:v>1.8743764597885839</c:v>
                </c:pt>
                <c:pt idx="28">
                  <c:v>1.8625235665940085</c:v>
                </c:pt>
                <c:pt idx="29">
                  <c:v>1.8862293529831591</c:v>
                </c:pt>
                <c:pt idx="30">
                  <c:v>2.5309216867686195</c:v>
                </c:pt>
                <c:pt idx="31">
                  <c:v>2.0381582479296259</c:v>
                </c:pt>
                <c:pt idx="32">
                  <c:v>2.2845399673491227</c:v>
                </c:pt>
                <c:pt idx="33">
                  <c:v>1.1691701473672784</c:v>
                </c:pt>
                <c:pt idx="34">
                  <c:v>1.30282065624382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25B5-40BE-AE88-87DE8E9ADA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8300640"/>
        <c:axId val="438298120"/>
      </c:scatterChart>
      <c:valAx>
        <c:axId val="438300640"/>
        <c:scaling>
          <c:orientation val="minMax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8298120"/>
        <c:crosses val="autoZero"/>
        <c:crossBetween val="midCat"/>
      </c:valAx>
      <c:valAx>
        <c:axId val="438298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83006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egendEntry>
        <c:idx val="6"/>
        <c:delete val="1"/>
      </c:legendEntry>
      <c:legendEntry>
        <c:idx val="7"/>
        <c:delete val="1"/>
      </c:legendEntry>
      <c:layout>
        <c:manualLayout>
          <c:xMode val="edge"/>
          <c:yMode val="edge"/>
          <c:x val="0.33256146106736656"/>
          <c:y val="0.88483741615631384"/>
          <c:w val="0.23886767279090113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1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i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gMADS08</a:t>
            </a:r>
            <a:endParaRPr lang="zh-CN" altLang="en-US" sz="800" i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PgMADS08!$J$1</c:f>
              <c:strCache>
                <c:ptCount val="1"/>
                <c:pt idx="0">
                  <c:v>Rg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47844588550983902"/>
                  <c:y val="-0.5051535616658626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0.0208x + 1.5219</a:t>
                    </a:r>
                    <a:br>
                      <a:rPr lang="en-US" altLang="zh-CN" sz="8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US" altLang="zh-CN" sz="8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1351, </a:t>
                    </a:r>
                    <a:r>
                      <a:rPr lang="en-US" altLang="zh-CN" sz="800" i="1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4389</a:t>
                    </a:r>
                    <a:endParaRPr lang="en-US" altLang="zh-CN" sz="80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PgMADS08!$I$2:$I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5.5730000000000002E-2</c:v>
                </c:pt>
                <c:pt idx="3">
                  <c:v>9.3682000000000001E-2</c:v>
                </c:pt>
                <c:pt idx="4">
                  <c:v>0</c:v>
                </c:pt>
                <c:pt idx="5">
                  <c:v>0.10285900000000001</c:v>
                </c:pt>
                <c:pt idx="6">
                  <c:v>0.54905199999999998</c:v>
                </c:pt>
                <c:pt idx="7">
                  <c:v>9.9579000000000001E-2</c:v>
                </c:pt>
                <c:pt idx="8">
                  <c:v>0.106423</c:v>
                </c:pt>
                <c:pt idx="9">
                  <c:v>0.263237</c:v>
                </c:pt>
                <c:pt idx="10">
                  <c:v>0</c:v>
                </c:pt>
                <c:pt idx="11">
                  <c:v>0</c:v>
                </c:pt>
                <c:pt idx="12">
                  <c:v>0.10419100000000001</c:v>
                </c:pt>
                <c:pt idx="13">
                  <c:v>0.13678599999999999</c:v>
                </c:pt>
                <c:pt idx="14">
                  <c:v>9.9994E-2</c:v>
                </c:pt>
                <c:pt idx="15">
                  <c:v>0.51012100000000005</c:v>
                </c:pt>
                <c:pt idx="16">
                  <c:v>0</c:v>
                </c:pt>
                <c:pt idx="17">
                  <c:v>9.3633999999999995E-2</c:v>
                </c:pt>
                <c:pt idx="18">
                  <c:v>5.8360000000000002E-2</c:v>
                </c:pt>
                <c:pt idx="19">
                  <c:v>0.32676500000000003</c:v>
                </c:pt>
                <c:pt idx="20">
                  <c:v>4.1187820000000004</c:v>
                </c:pt>
                <c:pt idx="21">
                  <c:v>0</c:v>
                </c:pt>
                <c:pt idx="22">
                  <c:v>5.5006000000000004</c:v>
                </c:pt>
                <c:pt idx="23">
                  <c:v>3.6918500000000001</c:v>
                </c:pt>
                <c:pt idx="24">
                  <c:v>9.9117999999999998E-2</c:v>
                </c:pt>
                <c:pt idx="25">
                  <c:v>0</c:v>
                </c:pt>
                <c:pt idx="26">
                  <c:v>4.8736000000000002E-2</c:v>
                </c:pt>
                <c:pt idx="27">
                  <c:v>0.25679400000000002</c:v>
                </c:pt>
                <c:pt idx="28">
                  <c:v>4.9974809999999996</c:v>
                </c:pt>
                <c:pt idx="29">
                  <c:v>0.10213899999999999</c:v>
                </c:pt>
                <c:pt idx="30">
                  <c:v>4.0674000000000002E-2</c:v>
                </c:pt>
                <c:pt idx="31">
                  <c:v>4.1989029999999996</c:v>
                </c:pt>
                <c:pt idx="32">
                  <c:v>0</c:v>
                </c:pt>
                <c:pt idx="33">
                  <c:v>0.150392</c:v>
                </c:pt>
                <c:pt idx="34">
                  <c:v>0.104631</c:v>
                </c:pt>
              </c:numCache>
            </c:numRef>
          </c:xVal>
          <c:yVal>
            <c:numRef>
              <c:f>PgMADS08!$J$2:$J$36</c:f>
              <c:numCache>
                <c:formatCode>General</c:formatCode>
                <c:ptCount val="35"/>
                <c:pt idx="0">
                  <c:v>1.3839999999999999</c:v>
                </c:pt>
                <c:pt idx="1">
                  <c:v>1.2130000000000001</c:v>
                </c:pt>
                <c:pt idx="2">
                  <c:v>1.2450000000000001</c:v>
                </c:pt>
                <c:pt idx="3">
                  <c:v>1.675</c:v>
                </c:pt>
                <c:pt idx="4">
                  <c:v>1.5389999999999999</c:v>
                </c:pt>
                <c:pt idx="5">
                  <c:v>1.8120000000000001</c:v>
                </c:pt>
                <c:pt idx="6">
                  <c:v>1.5629999999999999</c:v>
                </c:pt>
                <c:pt idx="7">
                  <c:v>1.554</c:v>
                </c:pt>
                <c:pt idx="8">
                  <c:v>1.4610000000000001</c:v>
                </c:pt>
                <c:pt idx="9">
                  <c:v>1.4770000000000001</c:v>
                </c:pt>
                <c:pt idx="10">
                  <c:v>1.385</c:v>
                </c:pt>
                <c:pt idx="11">
                  <c:v>1.6259999999999999</c:v>
                </c:pt>
                <c:pt idx="12">
                  <c:v>1.335</c:v>
                </c:pt>
                <c:pt idx="13">
                  <c:v>1.4339999999999999</c:v>
                </c:pt>
                <c:pt idx="14">
                  <c:v>1.335</c:v>
                </c:pt>
                <c:pt idx="15">
                  <c:v>1.64</c:v>
                </c:pt>
                <c:pt idx="16">
                  <c:v>1.6950000000000001</c:v>
                </c:pt>
                <c:pt idx="17">
                  <c:v>1.577</c:v>
                </c:pt>
                <c:pt idx="18">
                  <c:v>1.5920000000000001</c:v>
                </c:pt>
                <c:pt idx="19">
                  <c:v>1.613</c:v>
                </c:pt>
                <c:pt idx="20">
                  <c:v>1.6679999999999999</c:v>
                </c:pt>
                <c:pt idx="21">
                  <c:v>1.2629999999999999</c:v>
                </c:pt>
                <c:pt idx="22">
                  <c:v>1.383</c:v>
                </c:pt>
                <c:pt idx="23">
                  <c:v>1.1859999999999999</c:v>
                </c:pt>
                <c:pt idx="24">
                  <c:v>1.179</c:v>
                </c:pt>
                <c:pt idx="25">
                  <c:v>1.2290000000000001</c:v>
                </c:pt>
                <c:pt idx="26">
                  <c:v>1.093</c:v>
                </c:pt>
                <c:pt idx="27">
                  <c:v>2.0139999999999998</c:v>
                </c:pt>
                <c:pt idx="28">
                  <c:v>1.974</c:v>
                </c:pt>
                <c:pt idx="29">
                  <c:v>1.9330000000000001</c:v>
                </c:pt>
                <c:pt idx="30">
                  <c:v>1.617</c:v>
                </c:pt>
                <c:pt idx="31">
                  <c:v>1.7689999999999999</c:v>
                </c:pt>
                <c:pt idx="32">
                  <c:v>1.633</c:v>
                </c:pt>
                <c:pt idx="33">
                  <c:v>1.7250000000000001</c:v>
                </c:pt>
                <c:pt idx="34">
                  <c:v>1.985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B91-4952-A33D-220E6250DFD5}"/>
            </c:ext>
          </c:extLst>
        </c:ser>
        <c:ser>
          <c:idx val="1"/>
          <c:order val="1"/>
          <c:tx>
            <c:strRef>
              <c:f>PgMADS08!$K$1</c:f>
              <c:strCache>
                <c:ptCount val="1"/>
                <c:pt idx="0">
                  <c:v>Rb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2427549194991056"/>
                  <c:y val="-0.1745151953690304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0.4233x + 5.5925</a:t>
                    </a:r>
                    <a:b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2497, </a:t>
                    </a:r>
                    <a:r>
                      <a:rPr lang="en-US" altLang="zh-CN" sz="800" i="1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148</a:t>
                    </a:r>
                    <a:endParaRPr lang="en-US" altLang="zh-CN" sz="80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accent2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PgMADS08!$I$2:$I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5.5730000000000002E-2</c:v>
                </c:pt>
                <c:pt idx="3">
                  <c:v>9.3682000000000001E-2</c:v>
                </c:pt>
                <c:pt idx="4">
                  <c:v>0</c:v>
                </c:pt>
                <c:pt idx="5">
                  <c:v>0.10285900000000001</c:v>
                </c:pt>
                <c:pt idx="6">
                  <c:v>0.54905199999999998</c:v>
                </c:pt>
                <c:pt idx="7">
                  <c:v>9.9579000000000001E-2</c:v>
                </c:pt>
                <c:pt idx="8">
                  <c:v>0.106423</c:v>
                </c:pt>
                <c:pt idx="9">
                  <c:v>0.263237</c:v>
                </c:pt>
                <c:pt idx="10">
                  <c:v>0</c:v>
                </c:pt>
                <c:pt idx="11">
                  <c:v>0</c:v>
                </c:pt>
                <c:pt idx="12">
                  <c:v>0.10419100000000001</c:v>
                </c:pt>
                <c:pt idx="13">
                  <c:v>0.13678599999999999</c:v>
                </c:pt>
                <c:pt idx="14">
                  <c:v>9.9994E-2</c:v>
                </c:pt>
                <c:pt idx="15">
                  <c:v>0.51012100000000005</c:v>
                </c:pt>
                <c:pt idx="16">
                  <c:v>0</c:v>
                </c:pt>
                <c:pt idx="17">
                  <c:v>9.3633999999999995E-2</c:v>
                </c:pt>
                <c:pt idx="18">
                  <c:v>5.8360000000000002E-2</c:v>
                </c:pt>
                <c:pt idx="19">
                  <c:v>0.32676500000000003</c:v>
                </c:pt>
                <c:pt idx="20">
                  <c:v>4.1187820000000004</c:v>
                </c:pt>
                <c:pt idx="21">
                  <c:v>0</c:v>
                </c:pt>
                <c:pt idx="22">
                  <c:v>5.5006000000000004</c:v>
                </c:pt>
                <c:pt idx="23">
                  <c:v>3.6918500000000001</c:v>
                </c:pt>
                <c:pt idx="24">
                  <c:v>9.9117999999999998E-2</c:v>
                </c:pt>
                <c:pt idx="25">
                  <c:v>0</c:v>
                </c:pt>
                <c:pt idx="26">
                  <c:v>4.8736000000000002E-2</c:v>
                </c:pt>
                <c:pt idx="27">
                  <c:v>0.25679400000000002</c:v>
                </c:pt>
                <c:pt idx="28">
                  <c:v>4.9974809999999996</c:v>
                </c:pt>
                <c:pt idx="29">
                  <c:v>0.10213899999999999</c:v>
                </c:pt>
                <c:pt idx="30">
                  <c:v>4.0674000000000002E-2</c:v>
                </c:pt>
                <c:pt idx="31">
                  <c:v>4.1989029999999996</c:v>
                </c:pt>
                <c:pt idx="32">
                  <c:v>0</c:v>
                </c:pt>
                <c:pt idx="33">
                  <c:v>0.150392</c:v>
                </c:pt>
                <c:pt idx="34">
                  <c:v>0.104631</c:v>
                </c:pt>
              </c:numCache>
            </c:numRef>
          </c:xVal>
          <c:yVal>
            <c:numRef>
              <c:f>PgMADS08!$K$2:$K$36</c:f>
              <c:numCache>
                <c:formatCode>General</c:formatCode>
                <c:ptCount val="35"/>
                <c:pt idx="0">
                  <c:v>2.1715968170354896</c:v>
                </c:pt>
                <c:pt idx="1">
                  <c:v>2.0525280068302401</c:v>
                </c:pt>
                <c:pt idx="2">
                  <c:v>2.1120624119328646</c:v>
                </c:pt>
                <c:pt idx="3">
                  <c:v>2.5559379017952448</c:v>
                </c:pt>
                <c:pt idx="4">
                  <c:v>2.7278741622905476</c:v>
                </c:pt>
                <c:pt idx="5">
                  <c:v>2.8998104227858503</c:v>
                </c:pt>
                <c:pt idx="6">
                  <c:v>1.9736041936693041</c:v>
                </c:pt>
                <c:pt idx="7">
                  <c:v>2.5979172330463434</c:v>
                </c:pt>
                <c:pt idx="8">
                  <c:v>3.2222302724233827</c:v>
                </c:pt>
                <c:pt idx="9">
                  <c:v>3.904624387136213</c:v>
                </c:pt>
                <c:pt idx="10">
                  <c:v>4.1162594598555193</c:v>
                </c:pt>
                <c:pt idx="11">
                  <c:v>3.692989314416907</c:v>
                </c:pt>
                <c:pt idx="12">
                  <c:v>5.0961954554617259</c:v>
                </c:pt>
                <c:pt idx="13">
                  <c:v>5.2293647962536181</c:v>
                </c:pt>
                <c:pt idx="14">
                  <c:v>4.9630261146698338</c:v>
                </c:pt>
                <c:pt idx="15">
                  <c:v>5.4236484900219031</c:v>
                </c:pt>
                <c:pt idx="16">
                  <c:v>6.4026095597056454</c:v>
                </c:pt>
                <c:pt idx="17">
                  <c:v>7.3815706293893868</c:v>
                </c:pt>
                <c:pt idx="18">
                  <c:v>7.0548002083428552</c:v>
                </c:pt>
                <c:pt idx="19">
                  <c:v>6.3629253077424854</c:v>
                </c:pt>
                <c:pt idx="20">
                  <c:v>6.7088627580426703</c:v>
                </c:pt>
                <c:pt idx="21">
                  <c:v>7.6615008049587212</c:v>
                </c:pt>
                <c:pt idx="22">
                  <c:v>7.1563303367208864</c:v>
                </c:pt>
                <c:pt idx="23">
                  <c:v>7.4089155708398042</c:v>
                </c:pt>
                <c:pt idx="24">
                  <c:v>10.37559784428767</c:v>
                </c:pt>
                <c:pt idx="25">
                  <c:v>10.753920372229492</c:v>
                </c:pt>
                <c:pt idx="26">
                  <c:v>10.564759108258581</c:v>
                </c:pt>
                <c:pt idx="27">
                  <c:v>7.8490123896074229</c:v>
                </c:pt>
                <c:pt idx="28">
                  <c:v>8.1426393742903791</c:v>
                </c:pt>
                <c:pt idx="29">
                  <c:v>7.5553854049244666</c:v>
                </c:pt>
                <c:pt idx="30">
                  <c:v>9.8427135206888252</c:v>
                </c:pt>
                <c:pt idx="31">
                  <c:v>8.7293285798814733</c:v>
                </c:pt>
                <c:pt idx="32">
                  <c:v>9.2860210502851501</c:v>
                </c:pt>
                <c:pt idx="33">
                  <c:v>6.3003687616803914</c:v>
                </c:pt>
                <c:pt idx="34">
                  <c:v>6.42953011886726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B91-4952-A33D-220E6250DFD5}"/>
            </c:ext>
          </c:extLst>
        </c:ser>
        <c:ser>
          <c:idx val="2"/>
          <c:order val="2"/>
          <c:tx>
            <c:strRef>
              <c:f>PgMADS08!$L$1</c:f>
              <c:strCache>
                <c:ptCount val="1"/>
                <c:pt idx="0">
                  <c:v>Rd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5.4822848340290199E-2"/>
                  <c:y val="-0.4984547354880206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0.1012x + 1.301</a:t>
                    </a:r>
                    <a:br>
                      <a:rPr lang="en-US" altLang="zh-CN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US" altLang="zh-CN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2671, </a:t>
                    </a:r>
                    <a:r>
                      <a:rPr lang="en-US" altLang="zh-CN" sz="800" i="1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1209</a:t>
                    </a:r>
                    <a:endPara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PgMADS08!$I$2:$I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5.5730000000000002E-2</c:v>
                </c:pt>
                <c:pt idx="3">
                  <c:v>9.3682000000000001E-2</c:v>
                </c:pt>
                <c:pt idx="4">
                  <c:v>0</c:v>
                </c:pt>
                <c:pt idx="5">
                  <c:v>0.10285900000000001</c:v>
                </c:pt>
                <c:pt idx="6">
                  <c:v>0.54905199999999998</c:v>
                </c:pt>
                <c:pt idx="7">
                  <c:v>9.9579000000000001E-2</c:v>
                </c:pt>
                <c:pt idx="8">
                  <c:v>0.106423</c:v>
                </c:pt>
                <c:pt idx="9">
                  <c:v>0.263237</c:v>
                </c:pt>
                <c:pt idx="10">
                  <c:v>0</c:v>
                </c:pt>
                <c:pt idx="11">
                  <c:v>0</c:v>
                </c:pt>
                <c:pt idx="12">
                  <c:v>0.10419100000000001</c:v>
                </c:pt>
                <c:pt idx="13">
                  <c:v>0.13678599999999999</c:v>
                </c:pt>
                <c:pt idx="14">
                  <c:v>9.9994E-2</c:v>
                </c:pt>
                <c:pt idx="15">
                  <c:v>0.51012100000000005</c:v>
                </c:pt>
                <c:pt idx="16">
                  <c:v>0</c:v>
                </c:pt>
                <c:pt idx="17">
                  <c:v>9.3633999999999995E-2</c:v>
                </c:pt>
                <c:pt idx="18">
                  <c:v>5.8360000000000002E-2</c:v>
                </c:pt>
                <c:pt idx="19">
                  <c:v>0.32676500000000003</c:v>
                </c:pt>
                <c:pt idx="20">
                  <c:v>4.1187820000000004</c:v>
                </c:pt>
                <c:pt idx="21">
                  <c:v>0</c:v>
                </c:pt>
                <c:pt idx="22">
                  <c:v>5.5006000000000004</c:v>
                </c:pt>
                <c:pt idx="23">
                  <c:v>3.6918500000000001</c:v>
                </c:pt>
                <c:pt idx="24">
                  <c:v>9.9117999999999998E-2</c:v>
                </c:pt>
                <c:pt idx="25">
                  <c:v>0</c:v>
                </c:pt>
                <c:pt idx="26">
                  <c:v>4.8736000000000002E-2</c:v>
                </c:pt>
                <c:pt idx="27">
                  <c:v>0.25679400000000002</c:v>
                </c:pt>
                <c:pt idx="28">
                  <c:v>4.9974809999999996</c:v>
                </c:pt>
                <c:pt idx="29">
                  <c:v>0.10213899999999999</c:v>
                </c:pt>
                <c:pt idx="30">
                  <c:v>4.0674000000000002E-2</c:v>
                </c:pt>
                <c:pt idx="31">
                  <c:v>4.1989029999999996</c:v>
                </c:pt>
                <c:pt idx="32">
                  <c:v>0</c:v>
                </c:pt>
                <c:pt idx="33">
                  <c:v>0.150392</c:v>
                </c:pt>
                <c:pt idx="34">
                  <c:v>0.104631</c:v>
                </c:pt>
              </c:numCache>
            </c:numRef>
          </c:xVal>
          <c:yVal>
            <c:numRef>
              <c:f>PgMADS08!$L$2:$L$36</c:f>
              <c:numCache>
                <c:formatCode>General</c:formatCode>
                <c:ptCount val="35"/>
                <c:pt idx="0">
                  <c:v>0.60469553389179131</c:v>
                </c:pt>
                <c:pt idx="1">
                  <c:v>0.67930434672093831</c:v>
                </c:pt>
                <c:pt idx="2">
                  <c:v>0.61757654900337511</c:v>
                </c:pt>
                <c:pt idx="3">
                  <c:v>0.58679909011832021</c:v>
                </c:pt>
                <c:pt idx="4">
                  <c:v>0.62948409466337885</c:v>
                </c:pt>
                <c:pt idx="5">
                  <c:v>0.67216909920843748</c:v>
                </c:pt>
                <c:pt idx="6">
                  <c:v>0.87081751476292701</c:v>
                </c:pt>
                <c:pt idx="7">
                  <c:v>0.83690906987468916</c:v>
                </c:pt>
                <c:pt idx="8">
                  <c:v>0.90472595965116487</c:v>
                </c:pt>
                <c:pt idx="9">
                  <c:v>1.0236300411323342</c:v>
                </c:pt>
                <c:pt idx="10">
                  <c:v>0.95428468599889549</c:v>
                </c:pt>
                <c:pt idx="11">
                  <c:v>0.95566929354793895</c:v>
                </c:pt>
                <c:pt idx="12">
                  <c:v>0.99502701148142159</c:v>
                </c:pt>
                <c:pt idx="13">
                  <c:v>0.95649476075034179</c:v>
                </c:pt>
                <c:pt idx="14">
                  <c:v>0.9113322857649232</c:v>
                </c:pt>
                <c:pt idx="15">
                  <c:v>1.4515241625108004</c:v>
                </c:pt>
                <c:pt idx="16">
                  <c:v>1.572127039421324</c:v>
                </c:pt>
                <c:pt idx="17">
                  <c:v>1.6927299163318479</c:v>
                </c:pt>
                <c:pt idx="18">
                  <c:v>1.2248479157351744</c:v>
                </c:pt>
                <c:pt idx="19">
                  <c:v>1.2917019582872464</c:v>
                </c:pt>
                <c:pt idx="20">
                  <c:v>1.1579938731831021</c:v>
                </c:pt>
                <c:pt idx="21">
                  <c:v>1.8762668984631061</c:v>
                </c:pt>
                <c:pt idx="22">
                  <c:v>1.8983492237448403</c:v>
                </c:pt>
                <c:pt idx="23">
                  <c:v>1.8873080611039732</c:v>
                </c:pt>
                <c:pt idx="24">
                  <c:v>2.3185507016028506</c:v>
                </c:pt>
                <c:pt idx="25">
                  <c:v>2.4779851319663768</c:v>
                </c:pt>
                <c:pt idx="26">
                  <c:v>2.1591162712393244</c:v>
                </c:pt>
                <c:pt idx="27">
                  <c:v>1.8743764597885839</c:v>
                </c:pt>
                <c:pt idx="28">
                  <c:v>1.8625235665940085</c:v>
                </c:pt>
                <c:pt idx="29">
                  <c:v>1.8862293529831591</c:v>
                </c:pt>
                <c:pt idx="30">
                  <c:v>2.5309216867686195</c:v>
                </c:pt>
                <c:pt idx="31">
                  <c:v>2.0381582479296259</c:v>
                </c:pt>
                <c:pt idx="32">
                  <c:v>2.2845399673491227</c:v>
                </c:pt>
                <c:pt idx="33">
                  <c:v>1.1691701473672784</c:v>
                </c:pt>
                <c:pt idx="34">
                  <c:v>1.30282065624382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B91-4952-A33D-220E6250DF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8332000"/>
        <c:axId val="348332720"/>
      </c:scatterChart>
      <c:valAx>
        <c:axId val="348332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8332720"/>
        <c:crosses val="autoZero"/>
        <c:crossBetween val="midCat"/>
      </c:valAx>
      <c:valAx>
        <c:axId val="3483327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83320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gMADS37-01</a:t>
            </a:r>
            <a:endParaRPr lang="zh-CN" altLang="en-US" sz="800" i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PgMADS37-01'!$I$1</c:f>
              <c:strCache>
                <c:ptCount val="1"/>
                <c:pt idx="0">
                  <c:v>Rg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51431201550387595"/>
                  <c:y val="-0.5491755105322399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 dirty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0.0017x + 1.499</a:t>
                    </a:r>
                    <a:br>
                      <a:rPr lang="en-US" altLang="zh-CN" sz="800" baseline="0" dirty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 dirty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US" altLang="zh-CN" sz="800" baseline="0" dirty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07125, </a:t>
                    </a:r>
                    <a:r>
                      <a:rPr lang="en-US" altLang="zh-CN" sz="800" i="1" baseline="0" dirty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 dirty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6842</a:t>
                    </a:r>
                    <a:endParaRPr lang="en-US" altLang="zh-CN" sz="800" dirty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PgMADS37-01'!$H$2:$H$36</c:f>
              <c:numCache>
                <c:formatCode>General</c:formatCode>
                <c:ptCount val="35"/>
                <c:pt idx="0">
                  <c:v>4.5143459999999997</c:v>
                </c:pt>
                <c:pt idx="1">
                  <c:v>21.113365000000002</c:v>
                </c:pt>
                <c:pt idx="2">
                  <c:v>13.121916000000001</c:v>
                </c:pt>
                <c:pt idx="3">
                  <c:v>36.180860000000003</c:v>
                </c:pt>
                <c:pt idx="4">
                  <c:v>38.581831000000001</c:v>
                </c:pt>
                <c:pt idx="5">
                  <c:v>34.716470000000001</c:v>
                </c:pt>
                <c:pt idx="6">
                  <c:v>16.170718999999998</c:v>
                </c:pt>
                <c:pt idx="7">
                  <c:v>28.451279</c:v>
                </c:pt>
                <c:pt idx="8">
                  <c:v>35.110509999999998</c:v>
                </c:pt>
                <c:pt idx="9">
                  <c:v>40.472698000000001</c:v>
                </c:pt>
                <c:pt idx="10">
                  <c:v>47.245348999999997</c:v>
                </c:pt>
                <c:pt idx="11">
                  <c:v>25.367175</c:v>
                </c:pt>
                <c:pt idx="12">
                  <c:v>29.570398000000001</c:v>
                </c:pt>
                <c:pt idx="13">
                  <c:v>21.051594999999999</c:v>
                </c:pt>
                <c:pt idx="14">
                  <c:v>23.834564</c:v>
                </c:pt>
                <c:pt idx="15">
                  <c:v>25.946915000000001</c:v>
                </c:pt>
                <c:pt idx="16">
                  <c:v>3.0041920000000002</c:v>
                </c:pt>
                <c:pt idx="17">
                  <c:v>37.262425</c:v>
                </c:pt>
                <c:pt idx="18">
                  <c:v>21.277882999999999</c:v>
                </c:pt>
                <c:pt idx="19">
                  <c:v>24.202998000000001</c:v>
                </c:pt>
                <c:pt idx="20">
                  <c:v>13.699339999999999</c:v>
                </c:pt>
                <c:pt idx="21">
                  <c:v>20.583326</c:v>
                </c:pt>
                <c:pt idx="22">
                  <c:v>15.955266</c:v>
                </c:pt>
                <c:pt idx="23">
                  <c:v>14.583417000000001</c:v>
                </c:pt>
                <c:pt idx="24">
                  <c:v>21.217434999999998</c:v>
                </c:pt>
                <c:pt idx="25">
                  <c:v>22.033491000000001</c:v>
                </c:pt>
                <c:pt idx="26">
                  <c:v>19.530429999999999</c:v>
                </c:pt>
                <c:pt idx="27">
                  <c:v>33.740350999999997</c:v>
                </c:pt>
                <c:pt idx="28">
                  <c:v>15.435414</c:v>
                </c:pt>
                <c:pt idx="29">
                  <c:v>21.342390999999999</c:v>
                </c:pt>
                <c:pt idx="30">
                  <c:v>23.952203999999998</c:v>
                </c:pt>
                <c:pt idx="31">
                  <c:v>13.540990000000001</c:v>
                </c:pt>
                <c:pt idx="32">
                  <c:v>0.82683099999999998</c:v>
                </c:pt>
                <c:pt idx="33">
                  <c:v>22.843983000000001</c:v>
                </c:pt>
                <c:pt idx="34">
                  <c:v>25.471056999999998</c:v>
                </c:pt>
              </c:numCache>
            </c:numRef>
          </c:xVal>
          <c:yVal>
            <c:numRef>
              <c:f>'PgMADS37-01'!$I$2:$I$36</c:f>
              <c:numCache>
                <c:formatCode>General</c:formatCode>
                <c:ptCount val="35"/>
                <c:pt idx="0">
                  <c:v>1.3839999999999999</c:v>
                </c:pt>
                <c:pt idx="1">
                  <c:v>1.2130000000000001</c:v>
                </c:pt>
                <c:pt idx="2">
                  <c:v>1.2450000000000001</c:v>
                </c:pt>
                <c:pt idx="3">
                  <c:v>1.675</c:v>
                </c:pt>
                <c:pt idx="4">
                  <c:v>1.5389999999999999</c:v>
                </c:pt>
                <c:pt idx="5">
                  <c:v>1.8120000000000001</c:v>
                </c:pt>
                <c:pt idx="6">
                  <c:v>1.5629999999999999</c:v>
                </c:pt>
                <c:pt idx="7">
                  <c:v>1.554</c:v>
                </c:pt>
                <c:pt idx="8">
                  <c:v>1.4610000000000001</c:v>
                </c:pt>
                <c:pt idx="9">
                  <c:v>1.4770000000000001</c:v>
                </c:pt>
                <c:pt idx="10">
                  <c:v>1.385</c:v>
                </c:pt>
                <c:pt idx="11">
                  <c:v>1.6259999999999999</c:v>
                </c:pt>
                <c:pt idx="12">
                  <c:v>1.335</c:v>
                </c:pt>
                <c:pt idx="13">
                  <c:v>1.4339999999999999</c:v>
                </c:pt>
                <c:pt idx="14">
                  <c:v>1.335</c:v>
                </c:pt>
                <c:pt idx="15">
                  <c:v>1.64</c:v>
                </c:pt>
                <c:pt idx="16">
                  <c:v>1.6950000000000001</c:v>
                </c:pt>
                <c:pt idx="17">
                  <c:v>1.577</c:v>
                </c:pt>
                <c:pt idx="18">
                  <c:v>1.5920000000000001</c:v>
                </c:pt>
                <c:pt idx="19">
                  <c:v>1.613</c:v>
                </c:pt>
                <c:pt idx="20">
                  <c:v>1.6679999999999999</c:v>
                </c:pt>
                <c:pt idx="21">
                  <c:v>1.2629999999999999</c:v>
                </c:pt>
                <c:pt idx="22">
                  <c:v>1.383</c:v>
                </c:pt>
                <c:pt idx="23">
                  <c:v>1.1859999999999999</c:v>
                </c:pt>
                <c:pt idx="24">
                  <c:v>1.179</c:v>
                </c:pt>
                <c:pt idx="25">
                  <c:v>1.2290000000000001</c:v>
                </c:pt>
                <c:pt idx="26">
                  <c:v>1.093</c:v>
                </c:pt>
                <c:pt idx="27">
                  <c:v>2.0139999999999998</c:v>
                </c:pt>
                <c:pt idx="28">
                  <c:v>1.974</c:v>
                </c:pt>
                <c:pt idx="29">
                  <c:v>1.9330000000000001</c:v>
                </c:pt>
                <c:pt idx="30">
                  <c:v>1.617</c:v>
                </c:pt>
                <c:pt idx="31">
                  <c:v>1.7689999999999999</c:v>
                </c:pt>
                <c:pt idx="32">
                  <c:v>1.633</c:v>
                </c:pt>
                <c:pt idx="33">
                  <c:v>1.7250000000000001</c:v>
                </c:pt>
                <c:pt idx="34">
                  <c:v>1.985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605-494D-AE6C-18579FF18B23}"/>
            </c:ext>
          </c:extLst>
        </c:ser>
        <c:ser>
          <c:idx val="1"/>
          <c:order val="1"/>
          <c:tx>
            <c:strRef>
              <c:f>'PgMADS37-01'!$J$1</c:f>
              <c:strCache>
                <c:ptCount val="1"/>
                <c:pt idx="0">
                  <c:v>Rb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3911051480818923"/>
                  <c:y val="-0.4171036340247628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-0.0732x + 7.6049</a:t>
                    </a:r>
                    <a:b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-0.2874, </a:t>
                    </a:r>
                    <a:r>
                      <a:rPr lang="en-US" altLang="zh-CN" sz="800" i="1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0941</a:t>
                    </a:r>
                    <a:endParaRPr lang="en-US" altLang="zh-CN" sz="80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accent2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PgMADS37-01'!$H$2:$H$36</c:f>
              <c:numCache>
                <c:formatCode>General</c:formatCode>
                <c:ptCount val="35"/>
                <c:pt idx="0">
                  <c:v>4.5143459999999997</c:v>
                </c:pt>
                <c:pt idx="1">
                  <c:v>21.113365000000002</c:v>
                </c:pt>
                <c:pt idx="2">
                  <c:v>13.121916000000001</c:v>
                </c:pt>
                <c:pt idx="3">
                  <c:v>36.180860000000003</c:v>
                </c:pt>
                <c:pt idx="4">
                  <c:v>38.581831000000001</c:v>
                </c:pt>
                <c:pt idx="5">
                  <c:v>34.716470000000001</c:v>
                </c:pt>
                <c:pt idx="6">
                  <c:v>16.170718999999998</c:v>
                </c:pt>
                <c:pt idx="7">
                  <c:v>28.451279</c:v>
                </c:pt>
                <c:pt idx="8">
                  <c:v>35.110509999999998</c:v>
                </c:pt>
                <c:pt idx="9">
                  <c:v>40.472698000000001</c:v>
                </c:pt>
                <c:pt idx="10">
                  <c:v>47.245348999999997</c:v>
                </c:pt>
                <c:pt idx="11">
                  <c:v>25.367175</c:v>
                </c:pt>
                <c:pt idx="12">
                  <c:v>29.570398000000001</c:v>
                </c:pt>
                <c:pt idx="13">
                  <c:v>21.051594999999999</c:v>
                </c:pt>
                <c:pt idx="14">
                  <c:v>23.834564</c:v>
                </c:pt>
                <c:pt idx="15">
                  <c:v>25.946915000000001</c:v>
                </c:pt>
                <c:pt idx="16">
                  <c:v>3.0041920000000002</c:v>
                </c:pt>
                <c:pt idx="17">
                  <c:v>37.262425</c:v>
                </c:pt>
                <c:pt idx="18">
                  <c:v>21.277882999999999</c:v>
                </c:pt>
                <c:pt idx="19">
                  <c:v>24.202998000000001</c:v>
                </c:pt>
                <c:pt idx="20">
                  <c:v>13.699339999999999</c:v>
                </c:pt>
                <c:pt idx="21">
                  <c:v>20.583326</c:v>
                </c:pt>
                <c:pt idx="22">
                  <c:v>15.955266</c:v>
                </c:pt>
                <c:pt idx="23">
                  <c:v>14.583417000000001</c:v>
                </c:pt>
                <c:pt idx="24">
                  <c:v>21.217434999999998</c:v>
                </c:pt>
                <c:pt idx="25">
                  <c:v>22.033491000000001</c:v>
                </c:pt>
                <c:pt idx="26">
                  <c:v>19.530429999999999</c:v>
                </c:pt>
                <c:pt idx="27">
                  <c:v>33.740350999999997</c:v>
                </c:pt>
                <c:pt idx="28">
                  <c:v>15.435414</c:v>
                </c:pt>
                <c:pt idx="29">
                  <c:v>21.342390999999999</c:v>
                </c:pt>
                <c:pt idx="30">
                  <c:v>23.952203999999998</c:v>
                </c:pt>
                <c:pt idx="31">
                  <c:v>13.540990000000001</c:v>
                </c:pt>
                <c:pt idx="32">
                  <c:v>0.82683099999999998</c:v>
                </c:pt>
                <c:pt idx="33">
                  <c:v>22.843983000000001</c:v>
                </c:pt>
                <c:pt idx="34">
                  <c:v>25.471056999999998</c:v>
                </c:pt>
              </c:numCache>
            </c:numRef>
          </c:xVal>
          <c:yVal>
            <c:numRef>
              <c:f>'PgMADS37-01'!$J$2:$J$36</c:f>
              <c:numCache>
                <c:formatCode>General</c:formatCode>
                <c:ptCount val="35"/>
                <c:pt idx="0">
                  <c:v>2.1715968170354896</c:v>
                </c:pt>
                <c:pt idx="1">
                  <c:v>2.0525280068302401</c:v>
                </c:pt>
                <c:pt idx="2">
                  <c:v>2.1120624119328646</c:v>
                </c:pt>
                <c:pt idx="3">
                  <c:v>2.5559379017952448</c:v>
                </c:pt>
                <c:pt idx="4">
                  <c:v>2.7278741622905476</c:v>
                </c:pt>
                <c:pt idx="5">
                  <c:v>2.8998104227858503</c:v>
                </c:pt>
                <c:pt idx="6">
                  <c:v>1.9736041936693041</c:v>
                </c:pt>
                <c:pt idx="7">
                  <c:v>2.5979172330463434</c:v>
                </c:pt>
                <c:pt idx="8">
                  <c:v>3.2222302724233827</c:v>
                </c:pt>
                <c:pt idx="9">
                  <c:v>3.904624387136213</c:v>
                </c:pt>
                <c:pt idx="10">
                  <c:v>4.1162594598555193</c:v>
                </c:pt>
                <c:pt idx="11">
                  <c:v>3.692989314416907</c:v>
                </c:pt>
                <c:pt idx="12">
                  <c:v>5.0961954554617259</c:v>
                </c:pt>
                <c:pt idx="13">
                  <c:v>5.2293647962536181</c:v>
                </c:pt>
                <c:pt idx="14">
                  <c:v>4.9630261146698338</c:v>
                </c:pt>
                <c:pt idx="15">
                  <c:v>5.4236484900219031</c:v>
                </c:pt>
                <c:pt idx="16">
                  <c:v>6.4026095597056454</c:v>
                </c:pt>
                <c:pt idx="17">
                  <c:v>7.3815706293893868</c:v>
                </c:pt>
                <c:pt idx="18">
                  <c:v>7.0548002083428552</c:v>
                </c:pt>
                <c:pt idx="19">
                  <c:v>6.3629253077424854</c:v>
                </c:pt>
                <c:pt idx="20">
                  <c:v>6.7088627580426703</c:v>
                </c:pt>
                <c:pt idx="21">
                  <c:v>7.6615008049587212</c:v>
                </c:pt>
                <c:pt idx="22">
                  <c:v>7.1563303367208864</c:v>
                </c:pt>
                <c:pt idx="23">
                  <c:v>7.4089155708398042</c:v>
                </c:pt>
                <c:pt idx="24">
                  <c:v>10.37559784428767</c:v>
                </c:pt>
                <c:pt idx="25">
                  <c:v>10.753920372229492</c:v>
                </c:pt>
                <c:pt idx="26">
                  <c:v>10.564759108258581</c:v>
                </c:pt>
                <c:pt idx="27">
                  <c:v>7.8490123896074229</c:v>
                </c:pt>
                <c:pt idx="28">
                  <c:v>8.1426393742903791</c:v>
                </c:pt>
                <c:pt idx="29">
                  <c:v>7.5553854049244666</c:v>
                </c:pt>
                <c:pt idx="30">
                  <c:v>9.8427135206888252</c:v>
                </c:pt>
                <c:pt idx="31">
                  <c:v>8.7293285798814733</c:v>
                </c:pt>
                <c:pt idx="32">
                  <c:v>9.2860210502851501</c:v>
                </c:pt>
                <c:pt idx="33">
                  <c:v>6.3003687616803914</c:v>
                </c:pt>
                <c:pt idx="34">
                  <c:v>6.42953011886726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605-494D-AE6C-18579FF18B23}"/>
            </c:ext>
          </c:extLst>
        </c:ser>
        <c:ser>
          <c:idx val="2"/>
          <c:order val="2"/>
          <c:tx>
            <c:strRef>
              <c:f>'PgMADS37-01'!$K$1</c:f>
              <c:strCache>
                <c:ptCount val="1"/>
                <c:pt idx="0">
                  <c:v>Rd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4.4878751739216856E-2"/>
                  <c:y val="-0.58393029425952725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-0.0181x + 1.7948</a:t>
                    </a:r>
                    <a:br>
                      <a:rPr lang="en-US" altLang="zh-CN" sz="800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US" altLang="zh-CN" sz="800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-0.3172, </a:t>
                    </a:r>
                    <a:r>
                      <a:rPr lang="en-US" altLang="zh-CN" sz="800" i="1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0633</a:t>
                    </a:r>
                    <a:endParaRPr lang="en-US" altLang="zh-CN" sz="8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PgMADS37-01'!$H$2:$H$36</c:f>
              <c:numCache>
                <c:formatCode>General</c:formatCode>
                <c:ptCount val="35"/>
                <c:pt idx="0">
                  <c:v>4.5143459999999997</c:v>
                </c:pt>
                <c:pt idx="1">
                  <c:v>21.113365000000002</c:v>
                </c:pt>
                <c:pt idx="2">
                  <c:v>13.121916000000001</c:v>
                </c:pt>
                <c:pt idx="3">
                  <c:v>36.180860000000003</c:v>
                </c:pt>
                <c:pt idx="4">
                  <c:v>38.581831000000001</c:v>
                </c:pt>
                <c:pt idx="5">
                  <c:v>34.716470000000001</c:v>
                </c:pt>
                <c:pt idx="6">
                  <c:v>16.170718999999998</c:v>
                </c:pt>
                <c:pt idx="7">
                  <c:v>28.451279</c:v>
                </c:pt>
                <c:pt idx="8">
                  <c:v>35.110509999999998</c:v>
                </c:pt>
                <c:pt idx="9">
                  <c:v>40.472698000000001</c:v>
                </c:pt>
                <c:pt idx="10">
                  <c:v>47.245348999999997</c:v>
                </c:pt>
                <c:pt idx="11">
                  <c:v>25.367175</c:v>
                </c:pt>
                <c:pt idx="12">
                  <c:v>29.570398000000001</c:v>
                </c:pt>
                <c:pt idx="13">
                  <c:v>21.051594999999999</c:v>
                </c:pt>
                <c:pt idx="14">
                  <c:v>23.834564</c:v>
                </c:pt>
                <c:pt idx="15">
                  <c:v>25.946915000000001</c:v>
                </c:pt>
                <c:pt idx="16">
                  <c:v>3.0041920000000002</c:v>
                </c:pt>
                <c:pt idx="17">
                  <c:v>37.262425</c:v>
                </c:pt>
                <c:pt idx="18">
                  <c:v>21.277882999999999</c:v>
                </c:pt>
                <c:pt idx="19">
                  <c:v>24.202998000000001</c:v>
                </c:pt>
                <c:pt idx="20">
                  <c:v>13.699339999999999</c:v>
                </c:pt>
                <c:pt idx="21">
                  <c:v>20.583326</c:v>
                </c:pt>
                <c:pt idx="22">
                  <c:v>15.955266</c:v>
                </c:pt>
                <c:pt idx="23">
                  <c:v>14.583417000000001</c:v>
                </c:pt>
                <c:pt idx="24">
                  <c:v>21.217434999999998</c:v>
                </c:pt>
                <c:pt idx="25">
                  <c:v>22.033491000000001</c:v>
                </c:pt>
                <c:pt idx="26">
                  <c:v>19.530429999999999</c:v>
                </c:pt>
                <c:pt idx="27">
                  <c:v>33.740350999999997</c:v>
                </c:pt>
                <c:pt idx="28">
                  <c:v>15.435414</c:v>
                </c:pt>
                <c:pt idx="29">
                  <c:v>21.342390999999999</c:v>
                </c:pt>
                <c:pt idx="30">
                  <c:v>23.952203999999998</c:v>
                </c:pt>
                <c:pt idx="31">
                  <c:v>13.540990000000001</c:v>
                </c:pt>
                <c:pt idx="32">
                  <c:v>0.82683099999999998</c:v>
                </c:pt>
                <c:pt idx="33">
                  <c:v>22.843983000000001</c:v>
                </c:pt>
                <c:pt idx="34">
                  <c:v>25.471056999999998</c:v>
                </c:pt>
              </c:numCache>
            </c:numRef>
          </c:xVal>
          <c:yVal>
            <c:numRef>
              <c:f>'PgMADS37-01'!$K$2:$K$36</c:f>
              <c:numCache>
                <c:formatCode>General</c:formatCode>
                <c:ptCount val="35"/>
                <c:pt idx="0">
                  <c:v>0.60469553389179131</c:v>
                </c:pt>
                <c:pt idx="1">
                  <c:v>0.67930434672093831</c:v>
                </c:pt>
                <c:pt idx="2">
                  <c:v>0.61757654900337511</c:v>
                </c:pt>
                <c:pt idx="3">
                  <c:v>0.58679909011832021</c:v>
                </c:pt>
                <c:pt idx="4">
                  <c:v>0.62948409466337885</c:v>
                </c:pt>
                <c:pt idx="5">
                  <c:v>0.67216909920843748</c:v>
                </c:pt>
                <c:pt idx="6">
                  <c:v>0.87081751476292701</c:v>
                </c:pt>
                <c:pt idx="7">
                  <c:v>0.83690906987468916</c:v>
                </c:pt>
                <c:pt idx="8">
                  <c:v>0.90472595965116487</c:v>
                </c:pt>
                <c:pt idx="9">
                  <c:v>1.0236300411323342</c:v>
                </c:pt>
                <c:pt idx="10">
                  <c:v>0.95428468599889549</c:v>
                </c:pt>
                <c:pt idx="11">
                  <c:v>0.95566929354793895</c:v>
                </c:pt>
                <c:pt idx="12">
                  <c:v>0.99502701148142159</c:v>
                </c:pt>
                <c:pt idx="13">
                  <c:v>0.95649476075034179</c:v>
                </c:pt>
                <c:pt idx="14">
                  <c:v>0.9113322857649232</c:v>
                </c:pt>
                <c:pt idx="15">
                  <c:v>1.4515241625108004</c:v>
                </c:pt>
                <c:pt idx="16">
                  <c:v>1.572127039421324</c:v>
                </c:pt>
                <c:pt idx="17">
                  <c:v>1.6927299163318479</c:v>
                </c:pt>
                <c:pt idx="18">
                  <c:v>1.2248479157351744</c:v>
                </c:pt>
                <c:pt idx="19">
                  <c:v>1.2917019582872464</c:v>
                </c:pt>
                <c:pt idx="20">
                  <c:v>1.1579938731831021</c:v>
                </c:pt>
                <c:pt idx="21">
                  <c:v>1.8762668984631061</c:v>
                </c:pt>
                <c:pt idx="22">
                  <c:v>1.8983492237448403</c:v>
                </c:pt>
                <c:pt idx="23">
                  <c:v>1.8873080611039732</c:v>
                </c:pt>
                <c:pt idx="24">
                  <c:v>2.3185507016028506</c:v>
                </c:pt>
                <c:pt idx="25">
                  <c:v>2.4779851319663768</c:v>
                </c:pt>
                <c:pt idx="26">
                  <c:v>2.1591162712393244</c:v>
                </c:pt>
                <c:pt idx="27">
                  <c:v>1.8743764597885839</c:v>
                </c:pt>
                <c:pt idx="28">
                  <c:v>1.8625235665940085</c:v>
                </c:pt>
                <c:pt idx="29">
                  <c:v>1.8862293529831591</c:v>
                </c:pt>
                <c:pt idx="30">
                  <c:v>2.5309216867686195</c:v>
                </c:pt>
                <c:pt idx="31">
                  <c:v>2.0381582479296259</c:v>
                </c:pt>
                <c:pt idx="32">
                  <c:v>2.2845399673491227</c:v>
                </c:pt>
                <c:pt idx="33">
                  <c:v>1.1691701473672784</c:v>
                </c:pt>
                <c:pt idx="34">
                  <c:v>1.30282065624382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605-494D-AE6C-18579FF18B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9089976"/>
        <c:axId val="769091056"/>
      </c:scatterChart>
      <c:valAx>
        <c:axId val="7690899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69091056"/>
        <c:crosses val="autoZero"/>
        <c:crossBetween val="midCat"/>
      </c:valAx>
      <c:valAx>
        <c:axId val="769091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690899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1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i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gMADS37-05</a:t>
            </a:r>
            <a:endParaRPr lang="zh-CN" altLang="en-US" sz="800" i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PgMADS37-05'!$I$1</c:f>
              <c:strCache>
                <c:ptCount val="1"/>
                <c:pt idx="0">
                  <c:v>Rg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50760957066189627"/>
                  <c:y val="-0.5378927480302299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0.0227x + 1.4806</a:t>
                    </a:r>
                    <a:br>
                      <a:rPr lang="en-US" altLang="zh-CN" sz="8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US" altLang="zh-CN" sz="8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2035, </a:t>
                    </a:r>
                    <a:r>
                      <a:rPr lang="en-US" altLang="zh-CN" sz="800" i="1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>
                        <a:solidFill>
                          <a:schemeClr val="accent1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2411</a:t>
                    </a:r>
                    <a:endParaRPr lang="en-US" altLang="zh-CN" sz="80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PgMADS37-05'!$H$2:$H$36</c:f>
              <c:numCache>
                <c:formatCode>General</c:formatCode>
                <c:ptCount val="35"/>
                <c:pt idx="0">
                  <c:v>0</c:v>
                </c:pt>
                <c:pt idx="1">
                  <c:v>0.12565599999999999</c:v>
                </c:pt>
                <c:pt idx="2">
                  <c:v>0.13533899999999999</c:v>
                </c:pt>
                <c:pt idx="3">
                  <c:v>1.126905</c:v>
                </c:pt>
                <c:pt idx="4">
                  <c:v>0</c:v>
                </c:pt>
                <c:pt idx="5">
                  <c:v>0.25007299999999999</c:v>
                </c:pt>
                <c:pt idx="6">
                  <c:v>0</c:v>
                </c:pt>
                <c:pt idx="7">
                  <c:v>1.6251709999999999</c:v>
                </c:pt>
                <c:pt idx="8">
                  <c:v>0.34290399999999999</c:v>
                </c:pt>
                <c:pt idx="9">
                  <c:v>0.71124699999999996</c:v>
                </c:pt>
                <c:pt idx="10">
                  <c:v>1.5881460000000001</c:v>
                </c:pt>
                <c:pt idx="11">
                  <c:v>3.41805</c:v>
                </c:pt>
                <c:pt idx="12">
                  <c:v>2.4294389999999999</c:v>
                </c:pt>
                <c:pt idx="13">
                  <c:v>2.0708030000000002</c:v>
                </c:pt>
                <c:pt idx="14">
                  <c:v>2.815188</c:v>
                </c:pt>
                <c:pt idx="15">
                  <c:v>3.459111</c:v>
                </c:pt>
                <c:pt idx="16">
                  <c:v>0</c:v>
                </c:pt>
                <c:pt idx="17">
                  <c:v>2.974297</c:v>
                </c:pt>
                <c:pt idx="18">
                  <c:v>3.7401650000000002</c:v>
                </c:pt>
                <c:pt idx="19">
                  <c:v>2.4568979999999998</c:v>
                </c:pt>
                <c:pt idx="20">
                  <c:v>5.5941419999999997</c:v>
                </c:pt>
                <c:pt idx="21">
                  <c:v>4.2970040000000003</c:v>
                </c:pt>
                <c:pt idx="22">
                  <c:v>7.8104139999999997</c:v>
                </c:pt>
                <c:pt idx="23">
                  <c:v>2.9257710000000001</c:v>
                </c:pt>
                <c:pt idx="24">
                  <c:v>3.4845519999999999</c:v>
                </c:pt>
                <c:pt idx="25">
                  <c:v>3.1900719999999998</c:v>
                </c:pt>
                <c:pt idx="26">
                  <c:v>2.685146</c:v>
                </c:pt>
                <c:pt idx="27">
                  <c:v>9.3210499999999996</c:v>
                </c:pt>
                <c:pt idx="28">
                  <c:v>3.743465</c:v>
                </c:pt>
                <c:pt idx="29">
                  <c:v>4.2420939999999998</c:v>
                </c:pt>
                <c:pt idx="30">
                  <c:v>3.495619</c:v>
                </c:pt>
                <c:pt idx="31">
                  <c:v>4.1173070000000003</c:v>
                </c:pt>
                <c:pt idx="32">
                  <c:v>0</c:v>
                </c:pt>
                <c:pt idx="33">
                  <c:v>1.1711910000000001</c:v>
                </c:pt>
                <c:pt idx="34">
                  <c:v>1.867791</c:v>
                </c:pt>
              </c:numCache>
            </c:numRef>
          </c:xVal>
          <c:yVal>
            <c:numRef>
              <c:f>'PgMADS37-05'!$I$2:$I$36</c:f>
              <c:numCache>
                <c:formatCode>General</c:formatCode>
                <c:ptCount val="35"/>
                <c:pt idx="0">
                  <c:v>1.3839999999999999</c:v>
                </c:pt>
                <c:pt idx="1">
                  <c:v>1.2130000000000001</c:v>
                </c:pt>
                <c:pt idx="2">
                  <c:v>1.2450000000000001</c:v>
                </c:pt>
                <c:pt idx="3">
                  <c:v>1.675</c:v>
                </c:pt>
                <c:pt idx="4">
                  <c:v>1.5389999999999999</c:v>
                </c:pt>
                <c:pt idx="5">
                  <c:v>1.8120000000000001</c:v>
                </c:pt>
                <c:pt idx="6">
                  <c:v>1.5629999999999999</c:v>
                </c:pt>
                <c:pt idx="7">
                  <c:v>1.554</c:v>
                </c:pt>
                <c:pt idx="8">
                  <c:v>1.4610000000000001</c:v>
                </c:pt>
                <c:pt idx="9">
                  <c:v>1.4770000000000001</c:v>
                </c:pt>
                <c:pt idx="10">
                  <c:v>1.385</c:v>
                </c:pt>
                <c:pt idx="11">
                  <c:v>1.6259999999999999</c:v>
                </c:pt>
                <c:pt idx="12">
                  <c:v>1.335</c:v>
                </c:pt>
                <c:pt idx="13">
                  <c:v>1.4339999999999999</c:v>
                </c:pt>
                <c:pt idx="14">
                  <c:v>1.335</c:v>
                </c:pt>
                <c:pt idx="15">
                  <c:v>1.64</c:v>
                </c:pt>
                <c:pt idx="16">
                  <c:v>1.6950000000000001</c:v>
                </c:pt>
                <c:pt idx="17">
                  <c:v>1.577</c:v>
                </c:pt>
                <c:pt idx="18">
                  <c:v>1.5920000000000001</c:v>
                </c:pt>
                <c:pt idx="19">
                  <c:v>1.613</c:v>
                </c:pt>
                <c:pt idx="20">
                  <c:v>1.6679999999999999</c:v>
                </c:pt>
                <c:pt idx="21">
                  <c:v>1.2629999999999999</c:v>
                </c:pt>
                <c:pt idx="22">
                  <c:v>1.383</c:v>
                </c:pt>
                <c:pt idx="23">
                  <c:v>1.1859999999999999</c:v>
                </c:pt>
                <c:pt idx="24">
                  <c:v>1.179</c:v>
                </c:pt>
                <c:pt idx="25">
                  <c:v>1.2290000000000001</c:v>
                </c:pt>
                <c:pt idx="26">
                  <c:v>1.093</c:v>
                </c:pt>
                <c:pt idx="27">
                  <c:v>2.0139999999999998</c:v>
                </c:pt>
                <c:pt idx="28">
                  <c:v>1.974</c:v>
                </c:pt>
                <c:pt idx="29">
                  <c:v>1.9330000000000001</c:v>
                </c:pt>
                <c:pt idx="30">
                  <c:v>1.617</c:v>
                </c:pt>
                <c:pt idx="31">
                  <c:v>1.7689999999999999</c:v>
                </c:pt>
                <c:pt idx="32">
                  <c:v>1.633</c:v>
                </c:pt>
                <c:pt idx="33">
                  <c:v>1.7250000000000001</c:v>
                </c:pt>
                <c:pt idx="34">
                  <c:v>1.985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A74-4117-A787-86CD47433B06}"/>
            </c:ext>
          </c:extLst>
        </c:ser>
        <c:ser>
          <c:idx val="1"/>
          <c:order val="1"/>
          <c:tx>
            <c:strRef>
              <c:f>'PgMADS37-05'!$J$1</c:f>
              <c:strCache>
                <c:ptCount val="1"/>
                <c:pt idx="0">
                  <c:v>Rb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2677574040946133"/>
                  <c:y val="-7.2470252452162723E-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0.6689x + 4.239</a:t>
                    </a:r>
                    <a:b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5443, </a:t>
                    </a:r>
                    <a:r>
                      <a:rPr lang="en-US" altLang="zh-CN" sz="800" i="1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>
                        <a:solidFill>
                          <a:schemeClr val="accent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0007</a:t>
                    </a:r>
                    <a:endParaRPr lang="en-US" altLang="zh-CN" sz="80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accent2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PgMADS37-05'!$H$2:$H$36</c:f>
              <c:numCache>
                <c:formatCode>General</c:formatCode>
                <c:ptCount val="35"/>
                <c:pt idx="0">
                  <c:v>0</c:v>
                </c:pt>
                <c:pt idx="1">
                  <c:v>0.12565599999999999</c:v>
                </c:pt>
                <c:pt idx="2">
                  <c:v>0.13533899999999999</c:v>
                </c:pt>
                <c:pt idx="3">
                  <c:v>1.126905</c:v>
                </c:pt>
                <c:pt idx="4">
                  <c:v>0</c:v>
                </c:pt>
                <c:pt idx="5">
                  <c:v>0.25007299999999999</c:v>
                </c:pt>
                <c:pt idx="6">
                  <c:v>0</c:v>
                </c:pt>
                <c:pt idx="7">
                  <c:v>1.6251709999999999</c:v>
                </c:pt>
                <c:pt idx="8">
                  <c:v>0.34290399999999999</c:v>
                </c:pt>
                <c:pt idx="9">
                  <c:v>0.71124699999999996</c:v>
                </c:pt>
                <c:pt idx="10">
                  <c:v>1.5881460000000001</c:v>
                </c:pt>
                <c:pt idx="11">
                  <c:v>3.41805</c:v>
                </c:pt>
                <c:pt idx="12">
                  <c:v>2.4294389999999999</c:v>
                </c:pt>
                <c:pt idx="13">
                  <c:v>2.0708030000000002</c:v>
                </c:pt>
                <c:pt idx="14">
                  <c:v>2.815188</c:v>
                </c:pt>
                <c:pt idx="15">
                  <c:v>3.459111</c:v>
                </c:pt>
                <c:pt idx="16">
                  <c:v>0</c:v>
                </c:pt>
                <c:pt idx="17">
                  <c:v>2.974297</c:v>
                </c:pt>
                <c:pt idx="18">
                  <c:v>3.7401650000000002</c:v>
                </c:pt>
                <c:pt idx="19">
                  <c:v>2.4568979999999998</c:v>
                </c:pt>
                <c:pt idx="20">
                  <c:v>5.5941419999999997</c:v>
                </c:pt>
                <c:pt idx="21">
                  <c:v>4.2970040000000003</c:v>
                </c:pt>
                <c:pt idx="22">
                  <c:v>7.8104139999999997</c:v>
                </c:pt>
                <c:pt idx="23">
                  <c:v>2.9257710000000001</c:v>
                </c:pt>
                <c:pt idx="24">
                  <c:v>3.4845519999999999</c:v>
                </c:pt>
                <c:pt idx="25">
                  <c:v>3.1900719999999998</c:v>
                </c:pt>
                <c:pt idx="26">
                  <c:v>2.685146</c:v>
                </c:pt>
                <c:pt idx="27">
                  <c:v>9.3210499999999996</c:v>
                </c:pt>
                <c:pt idx="28">
                  <c:v>3.743465</c:v>
                </c:pt>
                <c:pt idx="29">
                  <c:v>4.2420939999999998</c:v>
                </c:pt>
                <c:pt idx="30">
                  <c:v>3.495619</c:v>
                </c:pt>
                <c:pt idx="31">
                  <c:v>4.1173070000000003</c:v>
                </c:pt>
                <c:pt idx="32">
                  <c:v>0</c:v>
                </c:pt>
                <c:pt idx="33">
                  <c:v>1.1711910000000001</c:v>
                </c:pt>
                <c:pt idx="34">
                  <c:v>1.867791</c:v>
                </c:pt>
              </c:numCache>
            </c:numRef>
          </c:xVal>
          <c:yVal>
            <c:numRef>
              <c:f>'PgMADS37-05'!$J$2:$J$36</c:f>
              <c:numCache>
                <c:formatCode>General</c:formatCode>
                <c:ptCount val="35"/>
                <c:pt idx="0">
                  <c:v>2.1715968170354896</c:v>
                </c:pt>
                <c:pt idx="1">
                  <c:v>2.0525280068302401</c:v>
                </c:pt>
                <c:pt idx="2">
                  <c:v>2.1120624119328646</c:v>
                </c:pt>
                <c:pt idx="3">
                  <c:v>2.5559379017952448</c:v>
                </c:pt>
                <c:pt idx="4">
                  <c:v>2.7278741622905476</c:v>
                </c:pt>
                <c:pt idx="5">
                  <c:v>2.8998104227858503</c:v>
                </c:pt>
                <c:pt idx="6">
                  <c:v>1.9736041936693041</c:v>
                </c:pt>
                <c:pt idx="7">
                  <c:v>2.5979172330463434</c:v>
                </c:pt>
                <c:pt idx="8">
                  <c:v>3.2222302724233827</c:v>
                </c:pt>
                <c:pt idx="9">
                  <c:v>3.904624387136213</c:v>
                </c:pt>
                <c:pt idx="10">
                  <c:v>4.1162594598555193</c:v>
                </c:pt>
                <c:pt idx="11">
                  <c:v>3.692989314416907</c:v>
                </c:pt>
                <c:pt idx="12">
                  <c:v>5.0961954554617259</c:v>
                </c:pt>
                <c:pt idx="13">
                  <c:v>5.2293647962536181</c:v>
                </c:pt>
                <c:pt idx="14">
                  <c:v>4.9630261146698338</c:v>
                </c:pt>
                <c:pt idx="15">
                  <c:v>5.4236484900219031</c:v>
                </c:pt>
                <c:pt idx="16">
                  <c:v>6.4026095597056454</c:v>
                </c:pt>
                <c:pt idx="17">
                  <c:v>7.3815706293893868</c:v>
                </c:pt>
                <c:pt idx="18">
                  <c:v>7.0548002083428552</c:v>
                </c:pt>
                <c:pt idx="19">
                  <c:v>6.3629253077424854</c:v>
                </c:pt>
                <c:pt idx="20">
                  <c:v>6.7088627580426703</c:v>
                </c:pt>
                <c:pt idx="21">
                  <c:v>7.6615008049587212</c:v>
                </c:pt>
                <c:pt idx="22">
                  <c:v>7.1563303367208864</c:v>
                </c:pt>
                <c:pt idx="23">
                  <c:v>7.4089155708398042</c:v>
                </c:pt>
                <c:pt idx="24">
                  <c:v>10.37559784428767</c:v>
                </c:pt>
                <c:pt idx="25">
                  <c:v>10.753920372229492</c:v>
                </c:pt>
                <c:pt idx="26">
                  <c:v>10.564759108258581</c:v>
                </c:pt>
                <c:pt idx="27">
                  <c:v>7.8490123896074229</c:v>
                </c:pt>
                <c:pt idx="28">
                  <c:v>8.1426393742903791</c:v>
                </c:pt>
                <c:pt idx="29">
                  <c:v>7.5553854049244666</c:v>
                </c:pt>
                <c:pt idx="30">
                  <c:v>9.8427135206888252</c:v>
                </c:pt>
                <c:pt idx="31">
                  <c:v>8.7293285798814733</c:v>
                </c:pt>
                <c:pt idx="32">
                  <c:v>9.2860210502851501</c:v>
                </c:pt>
                <c:pt idx="33">
                  <c:v>6.3003687616803914</c:v>
                </c:pt>
                <c:pt idx="34">
                  <c:v>6.42953011886726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A74-4117-A787-86CD47433B06}"/>
            </c:ext>
          </c:extLst>
        </c:ser>
        <c:ser>
          <c:idx val="2"/>
          <c:order val="2"/>
          <c:tx>
            <c:strRef>
              <c:f>'PgMADS37-05'!$K$1</c:f>
              <c:strCache>
                <c:ptCount val="1"/>
                <c:pt idx="0">
                  <c:v>Rd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4.1436344663088848E-2"/>
                  <c:y val="-0.50794661521144879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zh-CN" sz="800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0.1425x + 1.0209</a:t>
                    </a:r>
                    <a:br>
                      <a:rPr lang="en-US" altLang="zh-CN" sz="800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altLang="zh-CN" sz="800" i="1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US" altLang="zh-CN" sz="800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5189, </a:t>
                    </a:r>
                    <a:r>
                      <a:rPr lang="en-US" altLang="zh-CN" sz="800" i="1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US" altLang="zh-CN" sz="800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= 0.0014</a:t>
                    </a:r>
                    <a:endParaRPr lang="en-US" altLang="zh-CN" sz="8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PgMADS37-05'!$H$2:$H$36</c:f>
              <c:numCache>
                <c:formatCode>General</c:formatCode>
                <c:ptCount val="35"/>
                <c:pt idx="0">
                  <c:v>0</c:v>
                </c:pt>
                <c:pt idx="1">
                  <c:v>0.12565599999999999</c:v>
                </c:pt>
                <c:pt idx="2">
                  <c:v>0.13533899999999999</c:v>
                </c:pt>
                <c:pt idx="3">
                  <c:v>1.126905</c:v>
                </c:pt>
                <c:pt idx="4">
                  <c:v>0</c:v>
                </c:pt>
                <c:pt idx="5">
                  <c:v>0.25007299999999999</c:v>
                </c:pt>
                <c:pt idx="6">
                  <c:v>0</c:v>
                </c:pt>
                <c:pt idx="7">
                  <c:v>1.6251709999999999</c:v>
                </c:pt>
                <c:pt idx="8">
                  <c:v>0.34290399999999999</c:v>
                </c:pt>
                <c:pt idx="9">
                  <c:v>0.71124699999999996</c:v>
                </c:pt>
                <c:pt idx="10">
                  <c:v>1.5881460000000001</c:v>
                </c:pt>
                <c:pt idx="11">
                  <c:v>3.41805</c:v>
                </c:pt>
                <c:pt idx="12">
                  <c:v>2.4294389999999999</c:v>
                </c:pt>
                <c:pt idx="13">
                  <c:v>2.0708030000000002</c:v>
                </c:pt>
                <c:pt idx="14">
                  <c:v>2.815188</c:v>
                </c:pt>
                <c:pt idx="15">
                  <c:v>3.459111</c:v>
                </c:pt>
                <c:pt idx="16">
                  <c:v>0</c:v>
                </c:pt>
                <c:pt idx="17">
                  <c:v>2.974297</c:v>
                </c:pt>
                <c:pt idx="18">
                  <c:v>3.7401650000000002</c:v>
                </c:pt>
                <c:pt idx="19">
                  <c:v>2.4568979999999998</c:v>
                </c:pt>
                <c:pt idx="20">
                  <c:v>5.5941419999999997</c:v>
                </c:pt>
                <c:pt idx="21">
                  <c:v>4.2970040000000003</c:v>
                </c:pt>
                <c:pt idx="22">
                  <c:v>7.8104139999999997</c:v>
                </c:pt>
                <c:pt idx="23">
                  <c:v>2.9257710000000001</c:v>
                </c:pt>
                <c:pt idx="24">
                  <c:v>3.4845519999999999</c:v>
                </c:pt>
                <c:pt idx="25">
                  <c:v>3.1900719999999998</c:v>
                </c:pt>
                <c:pt idx="26">
                  <c:v>2.685146</c:v>
                </c:pt>
                <c:pt idx="27">
                  <c:v>9.3210499999999996</c:v>
                </c:pt>
                <c:pt idx="28">
                  <c:v>3.743465</c:v>
                </c:pt>
                <c:pt idx="29">
                  <c:v>4.2420939999999998</c:v>
                </c:pt>
                <c:pt idx="30">
                  <c:v>3.495619</c:v>
                </c:pt>
                <c:pt idx="31">
                  <c:v>4.1173070000000003</c:v>
                </c:pt>
                <c:pt idx="32">
                  <c:v>0</c:v>
                </c:pt>
                <c:pt idx="33">
                  <c:v>1.1711910000000001</c:v>
                </c:pt>
                <c:pt idx="34">
                  <c:v>1.867791</c:v>
                </c:pt>
              </c:numCache>
            </c:numRef>
          </c:xVal>
          <c:yVal>
            <c:numRef>
              <c:f>'PgMADS37-05'!$K$2:$K$36</c:f>
              <c:numCache>
                <c:formatCode>General</c:formatCode>
                <c:ptCount val="35"/>
                <c:pt idx="0">
                  <c:v>0.60469553389179131</c:v>
                </c:pt>
                <c:pt idx="1">
                  <c:v>0.67930434672093831</c:v>
                </c:pt>
                <c:pt idx="2">
                  <c:v>0.61757654900337511</c:v>
                </c:pt>
                <c:pt idx="3">
                  <c:v>0.58679909011832021</c:v>
                </c:pt>
                <c:pt idx="4">
                  <c:v>0.62948409466337885</c:v>
                </c:pt>
                <c:pt idx="5">
                  <c:v>0.67216909920843748</c:v>
                </c:pt>
                <c:pt idx="6">
                  <c:v>0.87081751476292701</c:v>
                </c:pt>
                <c:pt idx="7">
                  <c:v>0.83690906987468916</c:v>
                </c:pt>
                <c:pt idx="8">
                  <c:v>0.90472595965116487</c:v>
                </c:pt>
                <c:pt idx="9">
                  <c:v>1.0236300411323342</c:v>
                </c:pt>
                <c:pt idx="10">
                  <c:v>0.95428468599889549</c:v>
                </c:pt>
                <c:pt idx="11">
                  <c:v>0.95566929354793895</c:v>
                </c:pt>
                <c:pt idx="12">
                  <c:v>0.99502701148142159</c:v>
                </c:pt>
                <c:pt idx="13">
                  <c:v>0.95649476075034179</c:v>
                </c:pt>
                <c:pt idx="14">
                  <c:v>0.9113322857649232</c:v>
                </c:pt>
                <c:pt idx="15">
                  <c:v>1.4515241625108004</c:v>
                </c:pt>
                <c:pt idx="16">
                  <c:v>1.572127039421324</c:v>
                </c:pt>
                <c:pt idx="17">
                  <c:v>1.6927299163318479</c:v>
                </c:pt>
                <c:pt idx="18">
                  <c:v>1.2248479157351744</c:v>
                </c:pt>
                <c:pt idx="19">
                  <c:v>1.2917019582872464</c:v>
                </c:pt>
                <c:pt idx="20">
                  <c:v>1.1579938731831021</c:v>
                </c:pt>
                <c:pt idx="21">
                  <c:v>1.8762668984631061</c:v>
                </c:pt>
                <c:pt idx="22">
                  <c:v>1.8983492237448403</c:v>
                </c:pt>
                <c:pt idx="23">
                  <c:v>1.8873080611039732</c:v>
                </c:pt>
                <c:pt idx="24">
                  <c:v>2.3185507016028506</c:v>
                </c:pt>
                <c:pt idx="25">
                  <c:v>2.4779851319663768</c:v>
                </c:pt>
                <c:pt idx="26">
                  <c:v>2.1591162712393244</c:v>
                </c:pt>
                <c:pt idx="27">
                  <c:v>1.8743764597885839</c:v>
                </c:pt>
                <c:pt idx="28">
                  <c:v>1.8625235665940085</c:v>
                </c:pt>
                <c:pt idx="29">
                  <c:v>1.8862293529831591</c:v>
                </c:pt>
                <c:pt idx="30">
                  <c:v>2.5309216867686195</c:v>
                </c:pt>
                <c:pt idx="31">
                  <c:v>2.0381582479296259</c:v>
                </c:pt>
                <c:pt idx="32">
                  <c:v>2.2845399673491227</c:v>
                </c:pt>
                <c:pt idx="33">
                  <c:v>1.1691701473672784</c:v>
                </c:pt>
                <c:pt idx="34">
                  <c:v>1.30282065624382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A74-4117-A787-86CD47433B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2182528"/>
        <c:axId val="572179648"/>
      </c:scatterChart>
      <c:valAx>
        <c:axId val="572182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2179648"/>
        <c:crosses val="autoZero"/>
        <c:crossBetween val="midCat"/>
      </c:valAx>
      <c:valAx>
        <c:axId val="5721796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218252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2AA595-7B0C-4804-A3D3-D10A316482B2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6061C2-8720-48E1-9DD3-651C0B769A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2447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851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54161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2035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207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035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9012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9896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3984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376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8575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4781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A0C2BB-889A-4F2D-A36A-B6D63010FAF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3CF6A1-9E46-4EC1-9AED-8CD8FFEE5C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3826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37D09C32-160A-8CA2-4F90-F71E5A0B949A}"/>
              </a:ext>
            </a:extLst>
          </p:cNvPr>
          <p:cNvGrpSpPr/>
          <p:nvPr/>
        </p:nvGrpSpPr>
        <p:grpSpPr>
          <a:xfrm>
            <a:off x="408403" y="687976"/>
            <a:ext cx="8327194" cy="4947393"/>
            <a:chOff x="38485" y="995886"/>
            <a:chExt cx="8327194" cy="4947393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92E50BCA-BD17-1468-2173-9F7E9C38518A}"/>
                </a:ext>
              </a:extLst>
            </p:cNvPr>
            <p:cNvGrpSpPr/>
            <p:nvPr/>
          </p:nvGrpSpPr>
          <p:grpSpPr>
            <a:xfrm>
              <a:off x="38485" y="995886"/>
              <a:ext cx="8051156" cy="2506125"/>
              <a:chOff x="38485" y="995886"/>
              <a:chExt cx="8051156" cy="2506125"/>
            </a:xfrm>
          </p:grpSpPr>
          <p:graphicFrame>
            <p:nvGraphicFramePr>
              <p:cNvPr id="2" name="图表 1">
                <a:extLst>
                  <a:ext uri="{FF2B5EF4-FFF2-40B4-BE49-F238E27FC236}">
                    <a16:creationId xmlns:a16="http://schemas.microsoft.com/office/drawing/2014/main" id="{310197D3-5B15-D6BA-0328-CFDC4684A9D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93150564"/>
                  </p:ext>
                </p:extLst>
              </p:nvPr>
            </p:nvGraphicFramePr>
            <p:xfrm>
              <a:off x="4063285" y="995886"/>
              <a:ext cx="4026356" cy="248647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3" name="图表 2">
                <a:extLst>
                  <a:ext uri="{FF2B5EF4-FFF2-40B4-BE49-F238E27FC236}">
                    <a16:creationId xmlns:a16="http://schemas.microsoft.com/office/drawing/2014/main" id="{8A0F0EF1-5644-ECA7-76F6-C57B200CBF8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43780160"/>
                  </p:ext>
                </p:extLst>
              </p:nvPr>
            </p:nvGraphicFramePr>
            <p:xfrm>
              <a:off x="38485" y="1014411"/>
              <a:ext cx="4024800" cy="2487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C2EE1AD3-7DDB-DAA0-FA14-FBF31429865A}"/>
                </a:ext>
              </a:extLst>
            </p:cNvPr>
            <p:cNvGrpSpPr/>
            <p:nvPr/>
          </p:nvGrpSpPr>
          <p:grpSpPr>
            <a:xfrm>
              <a:off x="177282" y="3429000"/>
              <a:ext cx="8188397" cy="2514279"/>
              <a:chOff x="177282" y="3429000"/>
              <a:chExt cx="8188397" cy="2514279"/>
            </a:xfrm>
          </p:grpSpPr>
          <p:graphicFrame>
            <p:nvGraphicFramePr>
              <p:cNvPr id="4" name="图表 3">
                <a:extLst>
                  <a:ext uri="{FF2B5EF4-FFF2-40B4-BE49-F238E27FC236}">
                    <a16:creationId xmlns:a16="http://schemas.microsoft.com/office/drawing/2014/main" id="{CC562AF7-963E-191E-8908-97892161C80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58095321"/>
                  </p:ext>
                </p:extLst>
              </p:nvPr>
            </p:nvGraphicFramePr>
            <p:xfrm>
              <a:off x="177282" y="3429000"/>
              <a:ext cx="4024800" cy="2487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5" name="图表 4">
                <a:extLst>
                  <a:ext uri="{FF2B5EF4-FFF2-40B4-BE49-F238E27FC236}">
                    <a16:creationId xmlns:a16="http://schemas.microsoft.com/office/drawing/2014/main" id="{5AE982C8-2BE1-2CA0-42DC-79CA01330A8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71199597"/>
                  </p:ext>
                </p:extLst>
              </p:nvPr>
            </p:nvGraphicFramePr>
            <p:xfrm>
              <a:off x="4340879" y="3455679"/>
              <a:ext cx="4024800" cy="2487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</p:grpSp>
      <p:sp>
        <p:nvSpPr>
          <p:cNvPr id="9" name="TextBox 5">
            <a:extLst>
              <a:ext uri="{FF2B5EF4-FFF2-40B4-BE49-F238E27FC236}">
                <a16:creationId xmlns:a16="http://schemas.microsoft.com/office/drawing/2014/main" id="{EB3222CA-7A1D-6931-4C54-3467EFD58E96}"/>
              </a:ext>
            </a:extLst>
          </p:cNvPr>
          <p:cNvSpPr txBox="1"/>
          <p:nvPr/>
        </p:nvSpPr>
        <p:spPr>
          <a:xfrm>
            <a:off x="692649" y="5627215"/>
            <a:ext cx="78355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of the expression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</a:t>
            </a:r>
            <a:r>
              <a:rPr lang="en-GB" sz="1200">
                <a:latin typeface="Times New Roman" panose="02020603050405020304" pitchFamily="18" charset="0"/>
                <a:cs typeface="Times New Roman" panose="02020603050405020304" pitchFamily="18" charset="0"/>
              </a:rPr>
              <a:t>s of </a:t>
            </a:r>
            <a:r>
              <a:rPr lang="en-001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MADS08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001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MADS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  <a:r>
              <a:rPr lang="en-001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001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MADS37-01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001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MAD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r>
              <a:rPr lang="en-001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001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the contents of ginsenosides Rg1, R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Z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339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71</TotalTime>
  <Words>42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P Zhang</dc:creator>
  <cp:lastModifiedBy>Katleho Lephoto</cp:lastModifiedBy>
  <cp:revision>24</cp:revision>
  <dcterms:created xsi:type="dcterms:W3CDTF">2024-04-25T22:36:51Z</dcterms:created>
  <dcterms:modified xsi:type="dcterms:W3CDTF">2024-12-20T20:56:54Z</dcterms:modified>
</cp:coreProperties>
</file>